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B00F61-7DB5-483D-924F-F9D8672747CF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D16403-64DF-4E7A-B2C8-63F164DBD05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6189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4700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0248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322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5038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2148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73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767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234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475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5927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4286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0FBD3-4DE3-4A2D-97F8-6E6E60FC5C4A}" type="datetimeFigureOut">
              <a:rPr lang="ko-KR" altLang="en-US" smtClean="0"/>
              <a:t>2025-08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C498A-8C15-404C-B6D3-057985DC996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1618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5" Type="http://schemas.openxmlformats.org/officeDocument/2006/relationships/image" Target="../media/image4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Relationship Id="rId14" Type="http://schemas.openxmlformats.org/officeDocument/2006/relationships/image" Target="../media/image3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3">
            <a:extLst>
              <a:ext uri="{FF2B5EF4-FFF2-40B4-BE49-F238E27FC236}">
                <a16:creationId xmlns:a16="http://schemas.microsoft.com/office/drawing/2014/main" id="{A07CA7DC-032C-5EF3-60E1-C966C6A80058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A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A3AF84CB-8B94-9775-1630-29FEF7083983}"/>
              </a:ext>
            </a:extLst>
          </p:cNvPr>
          <p:cNvGrpSpPr/>
          <p:nvPr/>
        </p:nvGrpSpPr>
        <p:grpSpPr>
          <a:xfrm>
            <a:off x="3050595" y="1762621"/>
            <a:ext cx="3056758" cy="2908173"/>
            <a:chOff x="2382230" y="1587248"/>
            <a:chExt cx="3012174" cy="2908173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CB820D02-239F-7690-4B53-5C53D9553F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36936" y="1953821"/>
              <a:ext cx="2077563" cy="25416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028C14E-AC96-A27C-9BA8-5237F67E82C2}"/>
                </a:ext>
              </a:extLst>
            </p:cNvPr>
            <p:cNvSpPr txBox="1"/>
            <p:nvPr/>
          </p:nvSpPr>
          <p:spPr>
            <a:xfrm>
              <a:off x="3703256" y="1587248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_P3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CB78B59-1072-0EC8-12B9-FA1DE72FCA1A}"/>
                </a:ext>
              </a:extLst>
            </p:cNvPr>
            <p:cNvSpPr txBox="1"/>
            <p:nvPr/>
          </p:nvSpPr>
          <p:spPr>
            <a:xfrm>
              <a:off x="2382230" y="2077828"/>
              <a:ext cx="776026" cy="188269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D57757BB-EFF6-65E1-AFD0-03578DBED93B}"/>
              </a:ext>
            </a:extLst>
          </p:cNvPr>
          <p:cNvGrpSpPr/>
          <p:nvPr/>
        </p:nvGrpSpPr>
        <p:grpSpPr>
          <a:xfrm>
            <a:off x="5898145" y="1762621"/>
            <a:ext cx="2964674" cy="2863692"/>
            <a:chOff x="5931725" y="1754923"/>
            <a:chExt cx="2964674" cy="2863692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E81C7718-F48A-783C-D93F-C1DDB796FE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22559" y="2077015"/>
              <a:ext cx="2108313" cy="254160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990F20C-BF9D-F096-E552-554701D813F6}"/>
                </a:ext>
              </a:extLst>
            </p:cNvPr>
            <p:cNvSpPr txBox="1"/>
            <p:nvPr/>
          </p:nvSpPr>
          <p:spPr>
            <a:xfrm>
              <a:off x="7205251" y="1754923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_O1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4C68F27-91B3-FDFC-08EB-83EE4A2E8F8D}"/>
                </a:ext>
              </a:extLst>
            </p:cNvPr>
            <p:cNvSpPr txBox="1"/>
            <p:nvPr/>
          </p:nvSpPr>
          <p:spPr>
            <a:xfrm>
              <a:off x="5931725" y="2405308"/>
              <a:ext cx="776026" cy="144411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150000"/>
                </a:lnSpc>
              </a:pPr>
              <a:endPara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150000"/>
                </a:lnSpc>
              </a:pPr>
              <a:endPara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F280414-F674-AE34-09D6-6360618B072A}"/>
              </a:ext>
            </a:extLst>
          </p:cNvPr>
          <p:cNvSpPr txBox="1"/>
          <p:nvPr/>
        </p:nvSpPr>
        <p:spPr>
          <a:xfrm>
            <a:off x="3076277" y="1858372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55F60B7-5FDE-ED9A-51BD-B773040BDB1A}"/>
              </a:ext>
            </a:extLst>
          </p:cNvPr>
          <p:cNvSpPr txBox="1"/>
          <p:nvPr/>
        </p:nvSpPr>
        <p:spPr>
          <a:xfrm>
            <a:off x="5893032" y="1837870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63DC23-55B9-7537-A74F-F22A82523EC3}"/>
              </a:ext>
            </a:extLst>
          </p:cNvPr>
          <p:cNvSpPr txBox="1"/>
          <p:nvPr/>
        </p:nvSpPr>
        <p:spPr>
          <a:xfrm>
            <a:off x="3949578" y="1163213"/>
            <a:ext cx="4564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alpha - 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185B38F-D04C-34AC-C27D-8638DF81A8C6}"/>
              </a:ext>
            </a:extLst>
          </p:cNvPr>
          <p:cNvCxnSpPr>
            <a:cxnSpLocks/>
          </p:cNvCxnSpPr>
          <p:nvPr/>
        </p:nvCxnSpPr>
        <p:spPr>
          <a:xfrm>
            <a:off x="7513923" y="2296945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01091DC-B92F-5F54-E495-01F18416D4FF}"/>
              </a:ext>
            </a:extLst>
          </p:cNvPr>
          <p:cNvSpPr txBox="1"/>
          <p:nvPr/>
        </p:nvSpPr>
        <p:spPr>
          <a:xfrm>
            <a:off x="7673869" y="2243959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AB82DC6A-2394-9FB4-C0B4-D15E76CB5A40}"/>
              </a:ext>
            </a:extLst>
          </p:cNvPr>
          <p:cNvCxnSpPr>
            <a:cxnSpLocks/>
          </p:cNvCxnSpPr>
          <p:nvPr/>
        </p:nvCxnSpPr>
        <p:spPr>
          <a:xfrm>
            <a:off x="4712538" y="2388591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EDA6DE19-2549-F0D8-59BF-6F9F36BD8073}"/>
              </a:ext>
            </a:extLst>
          </p:cNvPr>
          <p:cNvSpPr txBox="1"/>
          <p:nvPr/>
        </p:nvSpPr>
        <p:spPr>
          <a:xfrm>
            <a:off x="4872484" y="2325877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A3F1857-AF2F-3909-FB40-70C302BABCC3}"/>
              </a:ext>
            </a:extLst>
          </p:cNvPr>
          <p:cNvSpPr txBox="1"/>
          <p:nvPr/>
        </p:nvSpPr>
        <p:spPr>
          <a:xfrm rot="16200000">
            <a:off x="4240686" y="3881361"/>
            <a:ext cx="752110" cy="16156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25C7E7B-6301-BF95-2223-851C912113AF}"/>
              </a:ext>
            </a:extLst>
          </p:cNvPr>
          <p:cNvSpPr txBox="1"/>
          <p:nvPr/>
        </p:nvSpPr>
        <p:spPr>
          <a:xfrm rot="16200000">
            <a:off x="7105934" y="3829368"/>
            <a:ext cx="752110" cy="16156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40054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32328A-177A-7376-B61B-EFD3B3FB22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FF53D8B-B6D8-E86D-D0F6-014C7468CAA2}"/>
              </a:ext>
            </a:extLst>
          </p:cNvPr>
          <p:cNvSpPr txBox="1"/>
          <p:nvPr/>
        </p:nvSpPr>
        <p:spPr>
          <a:xfrm>
            <a:off x="3163635" y="797053"/>
            <a:ext cx="57204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high beta – Fe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14" name="슬라이드 번호 개체 틀 3">
            <a:extLst>
              <a:ext uri="{FF2B5EF4-FFF2-40B4-BE49-F238E27FC236}">
                <a16:creationId xmlns:a16="http://schemas.microsoft.com/office/drawing/2014/main" id="{142C5EE7-D03F-53F8-A14C-B79F5DADDAB0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K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B3EE90B8-009E-427B-07DE-3C671B3FCA43}"/>
              </a:ext>
            </a:extLst>
          </p:cNvPr>
          <p:cNvGrpSpPr/>
          <p:nvPr/>
        </p:nvGrpSpPr>
        <p:grpSpPr>
          <a:xfrm>
            <a:off x="2896187" y="1767183"/>
            <a:ext cx="6440265" cy="3293153"/>
            <a:chOff x="1836152" y="1821401"/>
            <a:chExt cx="6440265" cy="3293153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D1569DD6-3392-4914-0A1D-AA3C6DAEF0B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35941" y="2202456"/>
              <a:ext cx="1994400" cy="2447673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4F6F7608-3B66-8178-7AC9-E574FB67CF2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15320" y="1821402"/>
              <a:ext cx="1000265" cy="381053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3EC765FD-5871-9F4D-6A67-A65575BDFB7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88063" y="2202456"/>
              <a:ext cx="1994400" cy="2440517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5780042D-2DF1-5A68-07E7-7AB8C669D9C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662879" y="1891261"/>
              <a:ext cx="885949" cy="23815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CAA197E-49C6-A914-380E-65A209A24087}"/>
                </a:ext>
              </a:extLst>
            </p:cNvPr>
            <p:cNvSpPr txBox="1"/>
            <p:nvPr/>
          </p:nvSpPr>
          <p:spPr>
            <a:xfrm>
              <a:off x="2847410" y="1821401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B_Cz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DE1929C-828E-BBB1-E5A4-59BB0D5815E0}"/>
                </a:ext>
              </a:extLst>
            </p:cNvPr>
            <p:cNvSpPr txBox="1"/>
            <p:nvPr/>
          </p:nvSpPr>
          <p:spPr>
            <a:xfrm>
              <a:off x="1836152" y="2090087"/>
              <a:ext cx="631383" cy="23158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</a:p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</a:p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</a:p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DA203D7-426B-E2EB-7301-7A446A9F90E4}"/>
                </a:ext>
              </a:extLst>
            </p:cNvPr>
            <p:cNvSpPr txBox="1"/>
            <p:nvPr/>
          </p:nvSpPr>
          <p:spPr>
            <a:xfrm rot="16200000">
              <a:off x="2845128" y="3884310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C3CCF01-6ADA-BDB1-18B2-607C8FC98EDD}"/>
                </a:ext>
              </a:extLst>
            </p:cNvPr>
            <p:cNvSpPr txBox="1"/>
            <p:nvPr/>
          </p:nvSpPr>
          <p:spPr>
            <a:xfrm>
              <a:off x="6585269" y="1863901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B_Oz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8E0D6EB-5162-BE14-7191-5E50543613F7}"/>
                </a:ext>
              </a:extLst>
            </p:cNvPr>
            <p:cNvSpPr txBox="1"/>
            <p:nvPr/>
          </p:nvSpPr>
          <p:spPr>
            <a:xfrm rot="16200000">
              <a:off x="6597250" y="3918723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96B1802-8BE7-30EE-4D34-C796A0C4E1B8}"/>
                </a:ext>
              </a:extLst>
            </p:cNvPr>
            <p:cNvSpPr txBox="1"/>
            <p:nvPr/>
          </p:nvSpPr>
          <p:spPr>
            <a:xfrm>
              <a:off x="5557206" y="2314062"/>
              <a:ext cx="631383" cy="20303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2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</a:p>
            <a:p>
              <a:pPr algn="r">
                <a:lnSpc>
                  <a:spcPct val="32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</a:p>
            <a:p>
              <a:pPr algn="r">
                <a:lnSpc>
                  <a:spcPct val="32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D3D65AD6-AD8D-AC76-BB1C-BE262315ED38}"/>
              </a:ext>
            </a:extLst>
          </p:cNvPr>
          <p:cNvSpPr txBox="1"/>
          <p:nvPr/>
        </p:nvSpPr>
        <p:spPr>
          <a:xfrm>
            <a:off x="2684508" y="1825796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4570E3-8C55-D1F5-A1F4-A817E5CF6014}"/>
              </a:ext>
            </a:extLst>
          </p:cNvPr>
          <p:cNvSpPr txBox="1"/>
          <p:nvPr/>
        </p:nvSpPr>
        <p:spPr>
          <a:xfrm>
            <a:off x="6352154" y="1825071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8A491FA0-9F8F-D4E2-9537-E39633CD16EA}"/>
              </a:ext>
            </a:extLst>
          </p:cNvPr>
          <p:cNvCxnSpPr>
            <a:cxnSpLocks/>
          </p:cNvCxnSpPr>
          <p:nvPr/>
        </p:nvCxnSpPr>
        <p:spPr>
          <a:xfrm>
            <a:off x="7939737" y="3089839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92CBB412-E9D7-CE94-1522-CFB8D4DE2B54}"/>
              </a:ext>
            </a:extLst>
          </p:cNvPr>
          <p:cNvSpPr txBox="1"/>
          <p:nvPr/>
        </p:nvSpPr>
        <p:spPr>
          <a:xfrm>
            <a:off x="7955200" y="308741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9753AF8B-A714-CCE2-40AF-C1A7891DD205}"/>
              </a:ext>
            </a:extLst>
          </p:cNvPr>
          <p:cNvCxnSpPr>
            <a:cxnSpLocks/>
          </p:cNvCxnSpPr>
          <p:nvPr/>
        </p:nvCxnSpPr>
        <p:spPr>
          <a:xfrm>
            <a:off x="7431514" y="2729980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61995CEB-2384-6C17-10B4-333C554C0C8D}"/>
              </a:ext>
            </a:extLst>
          </p:cNvPr>
          <p:cNvSpPr txBox="1"/>
          <p:nvPr/>
        </p:nvSpPr>
        <p:spPr>
          <a:xfrm>
            <a:off x="7672628" y="2729980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107635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그룹 15">
            <a:extLst>
              <a:ext uri="{FF2B5EF4-FFF2-40B4-BE49-F238E27FC236}">
                <a16:creationId xmlns:a16="http://schemas.microsoft.com/office/drawing/2014/main" id="{042AAAD6-999B-73BD-96F5-89B54A59CCAF}"/>
              </a:ext>
            </a:extLst>
          </p:cNvPr>
          <p:cNvGrpSpPr/>
          <p:nvPr/>
        </p:nvGrpSpPr>
        <p:grpSpPr>
          <a:xfrm>
            <a:off x="1912425" y="542604"/>
            <a:ext cx="7561229" cy="3213500"/>
            <a:chOff x="1096398" y="1574289"/>
            <a:chExt cx="9781180" cy="3946251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B976D6C4-F6FF-017D-C2A1-7C6613B652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30232" y="1971377"/>
              <a:ext cx="2544410" cy="3121143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AC429577-8CE3-795A-652F-061C09049A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14477" y="1612395"/>
              <a:ext cx="1286054" cy="28579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11E44372-805D-F9B8-8338-EEF17788738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02312" y="2011612"/>
              <a:ext cx="2675266" cy="2929335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B09DDC7F-5370-5B9F-7E77-0B5656B12D4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467937" y="1574289"/>
              <a:ext cx="781159" cy="362001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87A80EFF-0C62-694D-5BCC-D35A9A66CDE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13081" y="2024456"/>
              <a:ext cx="2608199" cy="3041398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4158657B-F490-1B5A-0656-20D16B13217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700534" y="1629685"/>
              <a:ext cx="876422" cy="409632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EE2A2C6-B1C9-A68D-3943-4471070CBEC6}"/>
                </a:ext>
              </a:extLst>
            </p:cNvPr>
            <p:cNvSpPr txBox="1"/>
            <p:nvPr/>
          </p:nvSpPr>
          <p:spPr>
            <a:xfrm>
              <a:off x="2462084" y="1652240"/>
              <a:ext cx="169114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_F3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A8B633F-3D2C-2AED-43B1-280B267D60A3}"/>
                </a:ext>
              </a:extLst>
            </p:cNvPr>
            <p:cNvSpPr txBox="1"/>
            <p:nvPr/>
          </p:nvSpPr>
          <p:spPr>
            <a:xfrm rot="16200000">
              <a:off x="2364647" y="4013746"/>
              <a:ext cx="923608" cy="20899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B5A9C4B-EFC8-B9DB-7A3A-DB340E51E99A}"/>
                </a:ext>
              </a:extLst>
            </p:cNvPr>
            <p:cNvSpPr txBox="1"/>
            <p:nvPr/>
          </p:nvSpPr>
          <p:spPr>
            <a:xfrm>
              <a:off x="1096398" y="1593547"/>
              <a:ext cx="776026" cy="31340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3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3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3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5425C93-4BF8-9C81-E2C7-D082A7AEB859}"/>
                </a:ext>
              </a:extLst>
            </p:cNvPr>
            <p:cNvSpPr txBox="1"/>
            <p:nvPr/>
          </p:nvSpPr>
          <p:spPr>
            <a:xfrm>
              <a:off x="5752967" y="1644014"/>
              <a:ext cx="169114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_F7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9AA6564-8A6D-86F3-DD3F-DEDAD146876A}"/>
                </a:ext>
              </a:extLst>
            </p:cNvPr>
            <p:cNvSpPr txBox="1"/>
            <p:nvPr/>
          </p:nvSpPr>
          <p:spPr>
            <a:xfrm>
              <a:off x="9082471" y="1619991"/>
              <a:ext cx="169114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_F8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8F9DDB2-E91B-2A36-D3F5-A7B11679F1A5}"/>
                </a:ext>
              </a:extLst>
            </p:cNvPr>
            <p:cNvSpPr txBox="1"/>
            <p:nvPr/>
          </p:nvSpPr>
          <p:spPr>
            <a:xfrm>
              <a:off x="7916074" y="1590396"/>
              <a:ext cx="555758" cy="313404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35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0.20.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B6AA54F-61DA-FD0A-00CD-E3A7D3CA6AF0}"/>
                </a:ext>
              </a:extLst>
            </p:cNvPr>
            <p:cNvSpPr txBox="1"/>
            <p:nvPr/>
          </p:nvSpPr>
          <p:spPr>
            <a:xfrm>
              <a:off x="4652226" y="2040514"/>
              <a:ext cx="555758" cy="231199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687359D7-74CA-ABD1-BDDC-739CBCEDB5D5}"/>
              </a:ext>
            </a:extLst>
          </p:cNvPr>
          <p:cNvGrpSpPr/>
          <p:nvPr/>
        </p:nvGrpSpPr>
        <p:grpSpPr>
          <a:xfrm>
            <a:off x="2939399" y="3408793"/>
            <a:ext cx="5628255" cy="3094181"/>
            <a:chOff x="2402533" y="1407693"/>
            <a:chExt cx="7310079" cy="3826948"/>
          </a:xfrm>
        </p:grpSpPr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315B4C02-FF8F-45A7-5F98-4947C952ED5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860562" y="2091137"/>
              <a:ext cx="2669824" cy="3143504"/>
            </a:xfrm>
            <a:prstGeom prst="rect">
              <a:avLst/>
            </a:prstGeom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1BA0EF98-E94F-69FC-07D6-D90809C10E4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89575" y="1512178"/>
              <a:ext cx="1362265" cy="428685"/>
            </a:xfrm>
            <a:prstGeom prst="rect">
              <a:avLst/>
            </a:prstGeom>
          </p:spPr>
        </p:pic>
        <p:pic>
          <p:nvPicPr>
            <p:cNvPr id="22" name="그림 21">
              <a:extLst>
                <a:ext uri="{FF2B5EF4-FFF2-40B4-BE49-F238E27FC236}">
                  <a16:creationId xmlns:a16="http://schemas.microsoft.com/office/drawing/2014/main" id="{EF4B1F02-F836-8767-DDE1-94F67108569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832480" y="2091137"/>
              <a:ext cx="2602122" cy="3143504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2BE4E112-2409-F671-F43B-C316EB9D5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827439" y="1407693"/>
              <a:ext cx="1000265" cy="476316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ECB69A0-BD96-47EC-D24A-BDBB8D3DEF42}"/>
                </a:ext>
              </a:extLst>
            </p:cNvPr>
            <p:cNvSpPr txBox="1"/>
            <p:nvPr/>
          </p:nvSpPr>
          <p:spPr>
            <a:xfrm>
              <a:off x="3814495" y="1658540"/>
              <a:ext cx="1691149" cy="4187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_Pz</a:t>
              </a:r>
              <a:endPara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F8259B0-DADB-D13F-E3C9-026F1BF1667F}"/>
                </a:ext>
              </a:extLst>
            </p:cNvPr>
            <p:cNvSpPr txBox="1"/>
            <p:nvPr/>
          </p:nvSpPr>
          <p:spPr>
            <a:xfrm>
              <a:off x="2402533" y="1892736"/>
              <a:ext cx="776026" cy="291422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2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2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F12B4C3-5B42-3466-FBB5-F2515D56CD38}"/>
                </a:ext>
              </a:extLst>
            </p:cNvPr>
            <p:cNvSpPr txBox="1"/>
            <p:nvPr/>
          </p:nvSpPr>
          <p:spPr>
            <a:xfrm>
              <a:off x="6268193" y="2150753"/>
              <a:ext cx="776026" cy="26644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17E5B93-4155-706C-0FBE-5171DFE02CF8}"/>
                </a:ext>
              </a:extLst>
            </p:cNvPr>
            <p:cNvSpPr txBox="1"/>
            <p:nvPr/>
          </p:nvSpPr>
          <p:spPr>
            <a:xfrm>
              <a:off x="7614197" y="1616630"/>
              <a:ext cx="2098415" cy="4187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_P4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29CB3836-59F8-FC00-DEE4-CE49825E1583}"/>
              </a:ext>
            </a:extLst>
          </p:cNvPr>
          <p:cNvSpPr txBox="1"/>
          <p:nvPr/>
        </p:nvSpPr>
        <p:spPr>
          <a:xfrm>
            <a:off x="3219952" y="133647"/>
            <a:ext cx="57204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alpha - Fe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31" name="슬라이드 번호 개체 틀 3">
            <a:extLst>
              <a:ext uri="{FF2B5EF4-FFF2-40B4-BE49-F238E27FC236}">
                <a16:creationId xmlns:a16="http://schemas.microsoft.com/office/drawing/2014/main" id="{191ADB2A-AE5C-697D-45C1-F08C55B0304B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B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1EE3E21-B0B3-DF75-C4D2-65015152FAD9}"/>
              </a:ext>
            </a:extLst>
          </p:cNvPr>
          <p:cNvSpPr txBox="1"/>
          <p:nvPr/>
        </p:nvSpPr>
        <p:spPr>
          <a:xfrm rot="16200000">
            <a:off x="5437839" y="2553400"/>
            <a:ext cx="752110" cy="16156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303E108-AC6D-538E-3D1D-76E3C0661CBC}"/>
              </a:ext>
            </a:extLst>
          </p:cNvPr>
          <p:cNvSpPr txBox="1"/>
          <p:nvPr/>
        </p:nvSpPr>
        <p:spPr>
          <a:xfrm rot="16200000">
            <a:off x="8112294" y="2530244"/>
            <a:ext cx="752110" cy="16156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4BEDC66-F6D3-2415-E47E-DEFCD19AE328}"/>
              </a:ext>
            </a:extLst>
          </p:cNvPr>
          <p:cNvSpPr txBox="1"/>
          <p:nvPr/>
        </p:nvSpPr>
        <p:spPr>
          <a:xfrm rot="16200000">
            <a:off x="3917305" y="5670695"/>
            <a:ext cx="752110" cy="16156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4579928-524C-6D60-D870-8A03976CF46D}"/>
              </a:ext>
            </a:extLst>
          </p:cNvPr>
          <p:cNvSpPr txBox="1"/>
          <p:nvPr/>
        </p:nvSpPr>
        <p:spPr>
          <a:xfrm rot="16200000">
            <a:off x="6932235" y="5696755"/>
            <a:ext cx="752110" cy="16156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%</a:t>
            </a:r>
          </a:p>
          <a:p>
            <a:pPr algn="r">
              <a:lnSpc>
                <a:spcPct val="2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ABA6F84-23B8-6FC8-01F8-53D8AA9DC340}"/>
              </a:ext>
            </a:extLst>
          </p:cNvPr>
          <p:cNvSpPr txBox="1"/>
          <p:nvPr/>
        </p:nvSpPr>
        <p:spPr>
          <a:xfrm>
            <a:off x="1767066" y="628412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9980F47-9C01-3250-90B8-57C092C3117D}"/>
              </a:ext>
            </a:extLst>
          </p:cNvPr>
          <p:cNvSpPr txBox="1"/>
          <p:nvPr/>
        </p:nvSpPr>
        <p:spPr>
          <a:xfrm>
            <a:off x="4293360" y="625294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4B1A4A9-5785-99B5-F2A3-C13C0E6CFE4E}"/>
              </a:ext>
            </a:extLst>
          </p:cNvPr>
          <p:cNvSpPr txBox="1"/>
          <p:nvPr/>
        </p:nvSpPr>
        <p:spPr>
          <a:xfrm>
            <a:off x="6851831" y="625293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D0FB911-E136-F772-2883-44DD2B73157F}"/>
              </a:ext>
            </a:extLst>
          </p:cNvPr>
          <p:cNvSpPr txBox="1"/>
          <p:nvPr/>
        </p:nvSpPr>
        <p:spPr>
          <a:xfrm>
            <a:off x="2772530" y="3721111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904CF86-84CA-A1C1-DB8D-8A0D93A3D450}"/>
              </a:ext>
            </a:extLst>
          </p:cNvPr>
          <p:cNvSpPr txBox="1"/>
          <p:nvPr/>
        </p:nvSpPr>
        <p:spPr>
          <a:xfrm>
            <a:off x="5725854" y="3701798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F044D7B0-781A-5D11-0815-4344260CC65A}"/>
              </a:ext>
            </a:extLst>
          </p:cNvPr>
          <p:cNvCxnSpPr>
            <a:cxnSpLocks/>
          </p:cNvCxnSpPr>
          <p:nvPr/>
        </p:nvCxnSpPr>
        <p:spPr>
          <a:xfrm>
            <a:off x="3298898" y="1121791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5F577AA4-C295-E54C-6A95-91DE73F3E5AD}"/>
              </a:ext>
            </a:extLst>
          </p:cNvPr>
          <p:cNvSpPr txBox="1"/>
          <p:nvPr/>
        </p:nvSpPr>
        <p:spPr>
          <a:xfrm>
            <a:off x="3381020" y="103962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9DF173EF-DE0A-B0BC-7A1D-D30A20ED2C0C}"/>
              </a:ext>
            </a:extLst>
          </p:cNvPr>
          <p:cNvCxnSpPr>
            <a:cxnSpLocks/>
          </p:cNvCxnSpPr>
          <p:nvPr/>
        </p:nvCxnSpPr>
        <p:spPr>
          <a:xfrm>
            <a:off x="5843936" y="1119270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E822522B-A91B-C19A-F57F-2136D2C835FA}"/>
              </a:ext>
            </a:extLst>
          </p:cNvPr>
          <p:cNvSpPr txBox="1"/>
          <p:nvPr/>
        </p:nvSpPr>
        <p:spPr>
          <a:xfrm>
            <a:off x="5974698" y="1037100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7648D83E-8724-4F95-9E50-72D7F58C4F55}"/>
              </a:ext>
            </a:extLst>
          </p:cNvPr>
          <p:cNvCxnSpPr>
            <a:cxnSpLocks/>
          </p:cNvCxnSpPr>
          <p:nvPr/>
        </p:nvCxnSpPr>
        <p:spPr>
          <a:xfrm>
            <a:off x="8485532" y="1284480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F8530AD-8DCA-871B-4DF3-9AAAF52DCB8E}"/>
              </a:ext>
            </a:extLst>
          </p:cNvPr>
          <p:cNvSpPr txBox="1"/>
          <p:nvPr/>
        </p:nvSpPr>
        <p:spPr>
          <a:xfrm>
            <a:off x="8567654" y="1202310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8533383B-60A5-01DB-4D01-263431D476BA}"/>
              </a:ext>
            </a:extLst>
          </p:cNvPr>
          <p:cNvCxnSpPr>
            <a:cxnSpLocks/>
          </p:cNvCxnSpPr>
          <p:nvPr/>
        </p:nvCxnSpPr>
        <p:spPr>
          <a:xfrm>
            <a:off x="4283639" y="4468848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DABA98AD-4DA1-7C1B-86A2-54CD5F0ADF5B}"/>
              </a:ext>
            </a:extLst>
          </p:cNvPr>
          <p:cNvSpPr txBox="1"/>
          <p:nvPr/>
        </p:nvSpPr>
        <p:spPr>
          <a:xfrm>
            <a:off x="4424129" y="4356393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2E5EF6D8-9F32-E323-F0B9-C2709733E7B8}"/>
              </a:ext>
            </a:extLst>
          </p:cNvPr>
          <p:cNvCxnSpPr>
            <a:cxnSpLocks/>
          </p:cNvCxnSpPr>
          <p:nvPr/>
        </p:nvCxnSpPr>
        <p:spPr>
          <a:xfrm>
            <a:off x="3527471" y="4551018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F4DA1CBD-F9EB-21D2-C76B-EFB8BE2AC28A}"/>
              </a:ext>
            </a:extLst>
          </p:cNvPr>
          <p:cNvSpPr txBox="1"/>
          <p:nvPr/>
        </p:nvSpPr>
        <p:spPr>
          <a:xfrm>
            <a:off x="3551225" y="4468848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C96C61A5-A7A9-8405-3488-FCD3D73B491A}"/>
              </a:ext>
            </a:extLst>
          </p:cNvPr>
          <p:cNvCxnSpPr>
            <a:cxnSpLocks/>
          </p:cNvCxnSpPr>
          <p:nvPr/>
        </p:nvCxnSpPr>
        <p:spPr>
          <a:xfrm>
            <a:off x="7324905" y="4491575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367161B2-3588-496B-395B-227F97156CC1}"/>
              </a:ext>
            </a:extLst>
          </p:cNvPr>
          <p:cNvSpPr txBox="1"/>
          <p:nvPr/>
        </p:nvSpPr>
        <p:spPr>
          <a:xfrm>
            <a:off x="7445939" y="4409405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1B0B7995-A447-4762-5931-89EA04CE6FBA}"/>
              </a:ext>
            </a:extLst>
          </p:cNvPr>
          <p:cNvCxnSpPr>
            <a:cxnSpLocks/>
          </p:cNvCxnSpPr>
          <p:nvPr/>
        </p:nvCxnSpPr>
        <p:spPr>
          <a:xfrm>
            <a:off x="5143838" y="1195448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DEF4C562-67E5-FF22-2126-67A03A09A3FB}"/>
              </a:ext>
            </a:extLst>
          </p:cNvPr>
          <p:cNvSpPr txBox="1"/>
          <p:nvPr/>
        </p:nvSpPr>
        <p:spPr>
          <a:xfrm>
            <a:off x="5109224" y="1113278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1345667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3E950D5-4F96-6867-8F9C-AA8AC1AECDCC}"/>
              </a:ext>
            </a:extLst>
          </p:cNvPr>
          <p:cNvSpPr txBox="1"/>
          <p:nvPr/>
        </p:nvSpPr>
        <p:spPr>
          <a:xfrm>
            <a:off x="3540401" y="433611"/>
            <a:ext cx="4662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beta - 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10" name="슬라이드 번호 개체 틀 3">
            <a:extLst>
              <a:ext uri="{FF2B5EF4-FFF2-40B4-BE49-F238E27FC236}">
                <a16:creationId xmlns:a16="http://schemas.microsoft.com/office/drawing/2014/main" id="{99993F80-7287-4554-6173-8C332426606B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C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BEFC3227-613D-581F-5505-1A31C08D4618}"/>
              </a:ext>
            </a:extLst>
          </p:cNvPr>
          <p:cNvGrpSpPr/>
          <p:nvPr/>
        </p:nvGrpSpPr>
        <p:grpSpPr>
          <a:xfrm>
            <a:off x="4337490" y="1687004"/>
            <a:ext cx="2870861" cy="3225857"/>
            <a:chOff x="4337490" y="1687004"/>
            <a:chExt cx="2870861" cy="3225857"/>
          </a:xfrm>
        </p:grpSpPr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55BFFC43-BC63-E54D-C1E4-6FC6313034DD}"/>
                </a:ext>
              </a:extLst>
            </p:cNvPr>
            <p:cNvGrpSpPr/>
            <p:nvPr/>
          </p:nvGrpSpPr>
          <p:grpSpPr>
            <a:xfrm>
              <a:off x="4337490" y="1687004"/>
              <a:ext cx="2870861" cy="2785525"/>
              <a:chOff x="4502862" y="1472995"/>
              <a:chExt cx="2870861" cy="2785525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1361AF43-3F2B-795E-FADD-50EAE117B25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05778" y="1781720"/>
                <a:ext cx="1980444" cy="2476800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1BC4B7E-F1C4-FD1C-C685-24EF0C3B677B}"/>
                  </a:ext>
                </a:extLst>
              </p:cNvPr>
              <p:cNvSpPr txBox="1"/>
              <p:nvPr/>
            </p:nvSpPr>
            <p:spPr>
              <a:xfrm>
                <a:off x="5682575" y="1472995"/>
                <a:ext cx="1691148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B_O2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C47C3B7-F5D2-FE62-5FCE-559E18B08A16}"/>
                  </a:ext>
                </a:extLst>
              </p:cNvPr>
              <p:cNvSpPr txBox="1"/>
              <p:nvPr/>
            </p:nvSpPr>
            <p:spPr>
              <a:xfrm>
                <a:off x="4502862" y="1860189"/>
                <a:ext cx="776026" cy="215969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ct val="400000"/>
                  </a:lnSpc>
                </a:pP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</a:p>
              <a:p>
                <a:pPr algn="r">
                  <a:lnSpc>
                    <a:spcPct val="400000"/>
                  </a:lnSpc>
                </a:pP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</a:t>
                </a:r>
              </a:p>
              <a:p>
                <a:pPr algn="r">
                  <a:lnSpc>
                    <a:spcPct val="400000"/>
                  </a:lnSpc>
                </a:pP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DA3B805-AB5A-42AB-5B97-5D137E448225}"/>
                </a:ext>
              </a:extLst>
            </p:cNvPr>
            <p:cNvSpPr txBox="1"/>
            <p:nvPr/>
          </p:nvSpPr>
          <p:spPr>
            <a:xfrm rot="16200000">
              <a:off x="5495774" y="3728988"/>
              <a:ext cx="752110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CA3B56BD-C43D-A6B5-6F75-2DFDD5978AC9}"/>
                </a:ext>
              </a:extLst>
            </p:cNvPr>
            <p:cNvCxnSpPr>
              <a:cxnSpLocks/>
            </p:cNvCxnSpPr>
            <p:nvPr/>
          </p:nvCxnSpPr>
          <p:spPr>
            <a:xfrm>
              <a:off x="5782399" y="2454183"/>
              <a:ext cx="879023" cy="0"/>
            </a:xfrm>
            <a:prstGeom prst="line">
              <a:avLst/>
            </a:prstGeom>
            <a:ln w="19050">
              <a:solidFill>
                <a:srgbClr val="C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B650FD4-C27B-7495-4216-CCB97E59F938}"/>
                </a:ext>
              </a:extLst>
            </p:cNvPr>
            <p:cNvSpPr txBox="1"/>
            <p:nvPr/>
          </p:nvSpPr>
          <p:spPr>
            <a:xfrm>
              <a:off x="5694850" y="2395251"/>
              <a:ext cx="725078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ko-KR" altLang="en-US" b="1" dirty="0">
                  <a:solidFill>
                    <a:srgbClr val="FF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2F2793BE-52CB-0D69-00FF-D6F4F9C0F1D3}"/>
              </a:ext>
            </a:extLst>
          </p:cNvPr>
          <p:cNvSpPr txBox="1"/>
          <p:nvPr/>
        </p:nvSpPr>
        <p:spPr>
          <a:xfrm>
            <a:off x="4337490" y="1681672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20716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그룹 17">
            <a:extLst>
              <a:ext uri="{FF2B5EF4-FFF2-40B4-BE49-F238E27FC236}">
                <a16:creationId xmlns:a16="http://schemas.microsoft.com/office/drawing/2014/main" id="{C387B4D7-369D-87D4-C75D-83F72E762F4C}"/>
              </a:ext>
            </a:extLst>
          </p:cNvPr>
          <p:cNvGrpSpPr/>
          <p:nvPr/>
        </p:nvGrpSpPr>
        <p:grpSpPr>
          <a:xfrm>
            <a:off x="1560441" y="838927"/>
            <a:ext cx="8151867" cy="3267655"/>
            <a:chOff x="1348005" y="1575065"/>
            <a:chExt cx="8151867" cy="3267655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AF039F9F-4F0E-2DD1-8022-27A18471A5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21167" y="1928498"/>
              <a:ext cx="2069750" cy="24768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B4B303F6-9677-4212-B005-D0F378DD846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64703" y="1928498"/>
              <a:ext cx="2154335" cy="2476800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E94A9CFC-DEED-46E8-5851-277A0617F69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032698" y="1883181"/>
              <a:ext cx="2085726" cy="2476800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3DC8385-CDFB-9B33-EBE2-83ADDC221612}"/>
                </a:ext>
              </a:extLst>
            </p:cNvPr>
            <p:cNvSpPr txBox="1"/>
            <p:nvPr/>
          </p:nvSpPr>
          <p:spPr>
            <a:xfrm rot="16200000">
              <a:off x="2438792" y="3642695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8214877-9A37-B02A-B6FD-C208272B94A9}"/>
                </a:ext>
              </a:extLst>
            </p:cNvPr>
            <p:cNvSpPr txBox="1"/>
            <p:nvPr/>
          </p:nvSpPr>
          <p:spPr>
            <a:xfrm>
              <a:off x="2432997" y="1599120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F8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5AE5C8-CF14-E910-498A-B2D05516A2A5}"/>
                </a:ext>
              </a:extLst>
            </p:cNvPr>
            <p:cNvSpPr txBox="1"/>
            <p:nvPr/>
          </p:nvSpPr>
          <p:spPr>
            <a:xfrm>
              <a:off x="1348005" y="1997673"/>
              <a:ext cx="672768" cy="20896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3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33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33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333B162-1AC0-D973-ED7C-ABA3EF5390DE}"/>
                </a:ext>
              </a:extLst>
            </p:cNvPr>
            <p:cNvSpPr txBox="1"/>
            <p:nvPr/>
          </p:nvSpPr>
          <p:spPr>
            <a:xfrm rot="16200000">
              <a:off x="5154425" y="3646889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CA7D070-0645-03B1-8C7D-C35FC7D47B53}"/>
                </a:ext>
              </a:extLst>
            </p:cNvPr>
            <p:cNvSpPr txBox="1"/>
            <p:nvPr/>
          </p:nvSpPr>
          <p:spPr>
            <a:xfrm rot="16200000">
              <a:off x="7702244" y="3596652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D96E9A3-3C42-3601-0CFD-24E50A31F30F}"/>
                </a:ext>
              </a:extLst>
            </p:cNvPr>
            <p:cNvSpPr txBox="1"/>
            <p:nvPr/>
          </p:nvSpPr>
          <p:spPr>
            <a:xfrm>
              <a:off x="5278698" y="1620382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G_Pz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48F95B7-C67E-5153-3AD9-CF60E3DCDACF}"/>
                </a:ext>
              </a:extLst>
            </p:cNvPr>
            <p:cNvSpPr txBox="1"/>
            <p:nvPr/>
          </p:nvSpPr>
          <p:spPr>
            <a:xfrm>
              <a:off x="7808724" y="1575065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F7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173A559-2984-74F5-8870-4D1E2F8638A4}"/>
                </a:ext>
              </a:extLst>
            </p:cNvPr>
            <p:cNvSpPr txBox="1"/>
            <p:nvPr/>
          </p:nvSpPr>
          <p:spPr>
            <a:xfrm>
              <a:off x="3977122" y="1575065"/>
              <a:ext cx="776026" cy="25582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F7B1A7F-E0A0-025E-3BC2-CA50138FC46C}"/>
                </a:ext>
              </a:extLst>
            </p:cNvPr>
            <p:cNvSpPr txBox="1"/>
            <p:nvPr/>
          </p:nvSpPr>
          <p:spPr>
            <a:xfrm>
              <a:off x="6533973" y="1800134"/>
              <a:ext cx="776026" cy="22404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</a:p>
            <a:p>
              <a:pPr algn="r">
                <a:lnSpc>
                  <a:spcPct val="1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4</a:t>
              </a:r>
            </a:p>
            <a:p>
              <a:pPr algn="r">
                <a:lnSpc>
                  <a:spcPct val="1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</a:p>
            <a:p>
              <a:pPr algn="r">
                <a:lnSpc>
                  <a:spcPct val="1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</a:p>
            <a:p>
              <a:pPr algn="r">
                <a:lnSpc>
                  <a:spcPct val="1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</a:p>
            <a:p>
              <a:pPr algn="r">
                <a:lnSpc>
                  <a:spcPct val="1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D5DC55F8-C544-11CA-A14C-0832A287B081}"/>
              </a:ext>
            </a:extLst>
          </p:cNvPr>
          <p:cNvSpPr txBox="1"/>
          <p:nvPr/>
        </p:nvSpPr>
        <p:spPr>
          <a:xfrm>
            <a:off x="3306593" y="316747"/>
            <a:ext cx="53413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gamma - 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20" name="슬라이드 번호 개체 틀 3">
            <a:extLst>
              <a:ext uri="{FF2B5EF4-FFF2-40B4-BE49-F238E27FC236}">
                <a16:creationId xmlns:a16="http://schemas.microsoft.com/office/drawing/2014/main" id="{F5FACF62-E323-0481-B609-F848DC94A5FC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E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7D806E-4333-2440-3438-9B4EC0D9EEDC}"/>
              </a:ext>
            </a:extLst>
          </p:cNvPr>
          <p:cNvSpPr txBox="1"/>
          <p:nvPr/>
        </p:nvSpPr>
        <p:spPr>
          <a:xfrm>
            <a:off x="1451374" y="946878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D52489D-F312-24E8-3F07-6AE54DE1B08A}"/>
              </a:ext>
            </a:extLst>
          </p:cNvPr>
          <p:cNvSpPr txBox="1"/>
          <p:nvPr/>
        </p:nvSpPr>
        <p:spPr>
          <a:xfrm>
            <a:off x="4166205" y="928570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8DB6CCA-3FF7-8D12-EDCB-B04A906D029C}"/>
              </a:ext>
            </a:extLst>
          </p:cNvPr>
          <p:cNvSpPr txBox="1"/>
          <p:nvPr/>
        </p:nvSpPr>
        <p:spPr>
          <a:xfrm>
            <a:off x="6678250" y="928570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AD8F5818-DAC9-02D1-7DED-2D02BDACA834}"/>
              </a:ext>
            </a:extLst>
          </p:cNvPr>
          <p:cNvGrpSpPr/>
          <p:nvPr/>
        </p:nvGrpSpPr>
        <p:grpSpPr>
          <a:xfrm>
            <a:off x="2954029" y="3678408"/>
            <a:ext cx="5453545" cy="3232316"/>
            <a:chOff x="3306600" y="1023395"/>
            <a:chExt cx="5453545" cy="3232316"/>
          </a:xfrm>
        </p:grpSpPr>
        <p:pic>
          <p:nvPicPr>
            <p:cNvPr id="64" name="그림 63">
              <a:extLst>
                <a:ext uri="{FF2B5EF4-FFF2-40B4-BE49-F238E27FC236}">
                  <a16:creationId xmlns:a16="http://schemas.microsoft.com/office/drawing/2014/main" id="{E78B94A6-2595-F26B-2077-1121F1294D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92267" y="1391433"/>
              <a:ext cx="1980000" cy="2444694"/>
            </a:xfrm>
            <a:prstGeom prst="rect">
              <a:avLst/>
            </a:prstGeom>
          </p:spPr>
        </p:pic>
        <p:pic>
          <p:nvPicPr>
            <p:cNvPr id="66" name="그림 65">
              <a:extLst>
                <a:ext uri="{FF2B5EF4-FFF2-40B4-BE49-F238E27FC236}">
                  <a16:creationId xmlns:a16="http://schemas.microsoft.com/office/drawing/2014/main" id="{433C235F-4B8F-837C-2CAD-D3D59DABBC9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37246" y="1366865"/>
              <a:ext cx="1980000" cy="2396136"/>
            </a:xfrm>
            <a:prstGeom prst="rect">
              <a:avLst/>
            </a:prstGeom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34D096B-24BE-88F7-1408-FFE25A7C57AC}"/>
                </a:ext>
              </a:extLst>
            </p:cNvPr>
            <p:cNvSpPr txBox="1"/>
            <p:nvPr/>
          </p:nvSpPr>
          <p:spPr>
            <a:xfrm rot="16200000">
              <a:off x="4468322" y="3059880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EC129E6-C6AF-4EBC-527B-059FA7D43F11}"/>
                </a:ext>
              </a:extLst>
            </p:cNvPr>
            <p:cNvSpPr txBox="1"/>
            <p:nvPr/>
          </p:nvSpPr>
          <p:spPr>
            <a:xfrm>
              <a:off x="4526534" y="1052879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T6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1C79423-7756-789B-A33B-BCCE3BCB59A2}"/>
                </a:ext>
              </a:extLst>
            </p:cNvPr>
            <p:cNvSpPr txBox="1"/>
            <p:nvPr/>
          </p:nvSpPr>
          <p:spPr>
            <a:xfrm>
              <a:off x="3306600" y="1359804"/>
              <a:ext cx="776026" cy="21542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6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4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B76FA31-CE18-AB84-62F9-C713E3DB7AAE}"/>
                </a:ext>
              </a:extLst>
            </p:cNvPr>
            <p:cNvSpPr txBox="1"/>
            <p:nvPr/>
          </p:nvSpPr>
          <p:spPr>
            <a:xfrm>
              <a:off x="7068997" y="1023395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T3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890A7F3-D67E-3850-0CDD-8E28D66429A5}"/>
                </a:ext>
              </a:extLst>
            </p:cNvPr>
            <p:cNvSpPr txBox="1"/>
            <p:nvPr/>
          </p:nvSpPr>
          <p:spPr>
            <a:xfrm rot="16200000">
              <a:off x="7040286" y="3020563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CDA13421-BD89-922B-E740-4DA8938C7828}"/>
                </a:ext>
              </a:extLst>
            </p:cNvPr>
            <p:cNvSpPr txBox="1"/>
            <p:nvPr/>
          </p:nvSpPr>
          <p:spPr>
            <a:xfrm>
              <a:off x="5846379" y="1569053"/>
              <a:ext cx="776026" cy="191187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942172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그룹 20">
            <a:extLst>
              <a:ext uri="{FF2B5EF4-FFF2-40B4-BE49-F238E27FC236}">
                <a16:creationId xmlns:a16="http://schemas.microsoft.com/office/drawing/2014/main" id="{48E9EFA6-0DAE-431C-7194-43DB0EB62DBC}"/>
              </a:ext>
            </a:extLst>
          </p:cNvPr>
          <p:cNvGrpSpPr/>
          <p:nvPr/>
        </p:nvGrpSpPr>
        <p:grpSpPr>
          <a:xfrm>
            <a:off x="396240" y="1659511"/>
            <a:ext cx="10897037" cy="3645315"/>
            <a:chOff x="425204" y="1679176"/>
            <a:chExt cx="10897037" cy="3645315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B9DDFB28-A824-9588-E2E1-1BC0F137741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28564" y="2127314"/>
              <a:ext cx="1980000" cy="2803299"/>
            </a:xfrm>
            <a:prstGeom prst="rect">
              <a:avLst/>
            </a:prstGeom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780A689C-2C4F-861B-E5C3-7176A7327C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59360" y="1822682"/>
              <a:ext cx="1095528" cy="362001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19D34D87-267A-1856-8000-B5D25271D486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48439" y="2127314"/>
              <a:ext cx="1980000" cy="2891752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BC4E4D3D-36B9-B1B1-2397-0A8FB6475B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09139" y="1679176"/>
              <a:ext cx="1019317" cy="485843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54073FB3-05A5-F3AA-777A-CEE252EEA0B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467947" y="2127314"/>
              <a:ext cx="1980000" cy="2803299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1450080B-821B-2550-AD82-1BBDCABAB84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351898" y="1746912"/>
              <a:ext cx="1200318" cy="400106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EF271C57-1156-44CC-2C24-3B69771DFD1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034864" y="2127315"/>
              <a:ext cx="1980000" cy="2891752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EF4620B2-F33C-3C4E-3AC5-D125C1500FA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201324" y="1679250"/>
              <a:ext cx="1028844" cy="43821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1F1A5D6-7FFC-FC45-AAA3-28656780BC62}"/>
                </a:ext>
              </a:extLst>
            </p:cNvPr>
            <p:cNvSpPr txBox="1"/>
            <p:nvPr/>
          </p:nvSpPr>
          <p:spPr>
            <a:xfrm rot="16200000">
              <a:off x="1409965" y="4054920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A70EC1-B0FD-64FC-5AD4-6BC40B16AFB2}"/>
                </a:ext>
              </a:extLst>
            </p:cNvPr>
            <p:cNvSpPr txBox="1"/>
            <p:nvPr/>
          </p:nvSpPr>
          <p:spPr>
            <a:xfrm>
              <a:off x="1574736" y="1779815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P4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F7C8D67-E732-F627-7DFF-5324874780E8}"/>
                </a:ext>
              </a:extLst>
            </p:cNvPr>
            <p:cNvSpPr txBox="1"/>
            <p:nvPr/>
          </p:nvSpPr>
          <p:spPr>
            <a:xfrm>
              <a:off x="425204" y="2065514"/>
              <a:ext cx="631383" cy="247785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29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4</a:t>
              </a:r>
            </a:p>
            <a:p>
              <a:pPr algn="r">
                <a:lnSpc>
                  <a:spcPct val="229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</a:p>
            <a:p>
              <a:pPr algn="r">
                <a:lnSpc>
                  <a:spcPct val="229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</a:p>
            <a:p>
              <a:pPr algn="r">
                <a:lnSpc>
                  <a:spcPct val="229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</a:p>
            <a:p>
              <a:pPr algn="r">
                <a:lnSpc>
                  <a:spcPct val="229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6301975-9F63-76C3-EB38-19B1219D1A63}"/>
                </a:ext>
              </a:extLst>
            </p:cNvPr>
            <p:cNvSpPr txBox="1"/>
            <p:nvPr/>
          </p:nvSpPr>
          <p:spPr>
            <a:xfrm rot="16200000">
              <a:off x="4138423" y="4099166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822F00B-94DC-AB53-C1CD-06695CA7B396}"/>
                </a:ext>
              </a:extLst>
            </p:cNvPr>
            <p:cNvSpPr txBox="1"/>
            <p:nvPr/>
          </p:nvSpPr>
          <p:spPr>
            <a:xfrm rot="16200000">
              <a:off x="7030752" y="4113914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D6A40A1-2D79-304A-F3FC-1B5ECB9027EB}"/>
                </a:ext>
              </a:extLst>
            </p:cNvPr>
            <p:cNvSpPr txBox="1"/>
            <p:nvPr/>
          </p:nvSpPr>
          <p:spPr>
            <a:xfrm rot="16200000">
              <a:off x="9663510" y="4128660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EDEBE11-6D07-A6DE-6297-5D568E06998E}"/>
                </a:ext>
              </a:extLst>
            </p:cNvPr>
            <p:cNvSpPr txBox="1"/>
            <p:nvPr/>
          </p:nvSpPr>
          <p:spPr>
            <a:xfrm>
              <a:off x="3271605" y="2060602"/>
              <a:ext cx="502949" cy="23966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8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6</a:t>
              </a:r>
            </a:p>
            <a:p>
              <a:pPr algn="r">
                <a:lnSpc>
                  <a:spcPct val="28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4</a:t>
              </a:r>
            </a:p>
            <a:p>
              <a:pPr algn="r">
                <a:lnSpc>
                  <a:spcPct val="28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</a:p>
            <a:p>
              <a:pPr algn="r">
                <a:lnSpc>
                  <a:spcPct val="28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28AE987-AE85-F8E9-C7FE-3DAAA908868A}"/>
                </a:ext>
              </a:extLst>
            </p:cNvPr>
            <p:cNvSpPr txBox="1"/>
            <p:nvPr/>
          </p:nvSpPr>
          <p:spPr>
            <a:xfrm>
              <a:off x="4275491" y="1788760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G_Oz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FC6DA4A-29B8-60BE-5893-E16F31681713}"/>
                </a:ext>
              </a:extLst>
            </p:cNvPr>
            <p:cNvSpPr txBox="1"/>
            <p:nvPr/>
          </p:nvSpPr>
          <p:spPr>
            <a:xfrm>
              <a:off x="7025261" y="1808464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T6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57A0917-B050-E555-BBE1-6E6DF5D183A0}"/>
                </a:ext>
              </a:extLst>
            </p:cNvPr>
            <p:cNvSpPr txBox="1"/>
            <p:nvPr/>
          </p:nvSpPr>
          <p:spPr>
            <a:xfrm>
              <a:off x="9631093" y="1801980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G_O2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F94E555-1237-CD92-963E-A5817ECE6999}"/>
                </a:ext>
              </a:extLst>
            </p:cNvPr>
            <p:cNvSpPr txBox="1"/>
            <p:nvPr/>
          </p:nvSpPr>
          <p:spPr>
            <a:xfrm>
              <a:off x="6172951" y="2259638"/>
              <a:ext cx="502949" cy="23158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</a:p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</a:p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</a:p>
            <a:p>
              <a:pPr algn="r">
                <a:lnSpc>
                  <a:spcPct val="27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6A59281-FE4B-CF3A-7DD4-9E4D61EF822A}"/>
                </a:ext>
              </a:extLst>
            </p:cNvPr>
            <p:cNvSpPr txBox="1"/>
            <p:nvPr/>
          </p:nvSpPr>
          <p:spPr>
            <a:xfrm>
              <a:off x="8775226" y="2176061"/>
              <a:ext cx="502949" cy="247785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2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4</a:t>
              </a:r>
            </a:p>
            <a:p>
              <a:pPr algn="r">
                <a:lnSpc>
                  <a:spcPct val="22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</a:p>
            <a:p>
              <a:pPr algn="r">
                <a:lnSpc>
                  <a:spcPct val="22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</a:p>
            <a:p>
              <a:pPr algn="r">
                <a:lnSpc>
                  <a:spcPct val="22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</a:p>
            <a:p>
              <a:pPr algn="r">
                <a:lnSpc>
                  <a:spcPct val="22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F289039D-67C9-5648-6F19-E11E81D75195}"/>
              </a:ext>
            </a:extLst>
          </p:cNvPr>
          <p:cNvSpPr txBox="1"/>
          <p:nvPr/>
        </p:nvSpPr>
        <p:spPr>
          <a:xfrm>
            <a:off x="3163635" y="797053"/>
            <a:ext cx="57204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gamma - Fe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24" name="슬라이드 번호 개체 틀 3">
            <a:extLst>
              <a:ext uri="{FF2B5EF4-FFF2-40B4-BE49-F238E27FC236}">
                <a16:creationId xmlns:a16="http://schemas.microsoft.com/office/drawing/2014/main" id="{7EA34076-95D3-2EA7-5651-F1F9E6D69C62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F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364768B-08D6-074A-AB96-14E7A1D70987}"/>
              </a:ext>
            </a:extLst>
          </p:cNvPr>
          <p:cNvSpPr txBox="1"/>
          <p:nvPr/>
        </p:nvSpPr>
        <p:spPr>
          <a:xfrm>
            <a:off x="217708" y="1813092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33A3B5E-D49D-5AF6-DEE2-9A8C96B723F3}"/>
              </a:ext>
            </a:extLst>
          </p:cNvPr>
          <p:cNvSpPr txBox="1"/>
          <p:nvPr/>
        </p:nvSpPr>
        <p:spPr>
          <a:xfrm>
            <a:off x="2942726" y="1813751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22EAD7A-D0B3-329C-E70B-17B05AFB7C3B}"/>
              </a:ext>
            </a:extLst>
          </p:cNvPr>
          <p:cNvSpPr txBox="1"/>
          <p:nvPr/>
        </p:nvSpPr>
        <p:spPr>
          <a:xfrm>
            <a:off x="5835325" y="1813177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EE42497-E81B-9F5D-41F8-365C94F19255}"/>
              </a:ext>
            </a:extLst>
          </p:cNvPr>
          <p:cNvSpPr txBox="1"/>
          <p:nvPr/>
        </p:nvSpPr>
        <p:spPr>
          <a:xfrm>
            <a:off x="8454133" y="1803016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CAA67704-F5E1-F7E0-98CA-EF5494E9D60A}"/>
              </a:ext>
            </a:extLst>
          </p:cNvPr>
          <p:cNvCxnSpPr>
            <a:cxnSpLocks/>
          </p:cNvCxnSpPr>
          <p:nvPr/>
        </p:nvCxnSpPr>
        <p:spPr>
          <a:xfrm>
            <a:off x="1650238" y="2974736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CF05EE9-28FE-F91F-BBEF-5744B83B85BE}"/>
              </a:ext>
            </a:extLst>
          </p:cNvPr>
          <p:cNvSpPr txBox="1"/>
          <p:nvPr/>
        </p:nvSpPr>
        <p:spPr>
          <a:xfrm>
            <a:off x="1611403" y="2912022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0EBBA122-992D-D50A-401C-B1700FB73FDB}"/>
              </a:ext>
            </a:extLst>
          </p:cNvPr>
          <p:cNvCxnSpPr>
            <a:cxnSpLocks/>
          </p:cNvCxnSpPr>
          <p:nvPr/>
        </p:nvCxnSpPr>
        <p:spPr>
          <a:xfrm>
            <a:off x="4358265" y="2933888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627705FF-26C2-4EB1-4B33-868258271DDE}"/>
              </a:ext>
            </a:extLst>
          </p:cNvPr>
          <p:cNvSpPr txBox="1"/>
          <p:nvPr/>
        </p:nvSpPr>
        <p:spPr>
          <a:xfrm>
            <a:off x="4299553" y="290099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37AE3B76-4BC4-758F-530F-F7E3CFA0EB74}"/>
              </a:ext>
            </a:extLst>
          </p:cNvPr>
          <p:cNvCxnSpPr>
            <a:cxnSpLocks/>
          </p:cNvCxnSpPr>
          <p:nvPr/>
        </p:nvCxnSpPr>
        <p:spPr>
          <a:xfrm>
            <a:off x="7252809" y="3017927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D59EC7C-540F-7AB6-9505-43D943CEFBBB}"/>
              </a:ext>
            </a:extLst>
          </p:cNvPr>
          <p:cNvSpPr txBox="1"/>
          <p:nvPr/>
        </p:nvSpPr>
        <p:spPr>
          <a:xfrm>
            <a:off x="7233853" y="2965152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4B913842-522F-B3E7-3DD9-44D7FD359AA0}"/>
              </a:ext>
            </a:extLst>
          </p:cNvPr>
          <p:cNvCxnSpPr>
            <a:cxnSpLocks/>
          </p:cNvCxnSpPr>
          <p:nvPr/>
        </p:nvCxnSpPr>
        <p:spPr>
          <a:xfrm>
            <a:off x="9813729" y="2780660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AEEF3482-BE57-9FE7-D41A-1A08F3521F68}"/>
              </a:ext>
            </a:extLst>
          </p:cNvPr>
          <p:cNvSpPr txBox="1"/>
          <p:nvPr/>
        </p:nvSpPr>
        <p:spPr>
          <a:xfrm>
            <a:off x="9755016" y="2747763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25466794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5F8FED-55FF-66A5-3A8A-32179BC811F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그룹 46">
            <a:extLst>
              <a:ext uri="{FF2B5EF4-FFF2-40B4-BE49-F238E27FC236}">
                <a16:creationId xmlns:a16="http://schemas.microsoft.com/office/drawing/2014/main" id="{7AFEC822-9F3B-A79C-C471-09DB9257BDA7}"/>
              </a:ext>
            </a:extLst>
          </p:cNvPr>
          <p:cNvGrpSpPr/>
          <p:nvPr/>
        </p:nvGrpSpPr>
        <p:grpSpPr>
          <a:xfrm>
            <a:off x="603962" y="54226"/>
            <a:ext cx="11474064" cy="6881056"/>
            <a:chOff x="603962" y="54226"/>
            <a:chExt cx="11474064" cy="6881056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58A228F-9E8C-B3CF-5928-37A06FF8114E}"/>
                </a:ext>
              </a:extLst>
            </p:cNvPr>
            <p:cNvSpPr txBox="1"/>
            <p:nvPr/>
          </p:nvSpPr>
          <p:spPr>
            <a:xfrm>
              <a:off x="3163636" y="54226"/>
              <a:ext cx="57204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Times New Roman" panose="02020603050405020304" pitchFamily="18" charset="0"/>
                  <a:ea typeface="바탕" panose="02030600000101010101" pitchFamily="18" charset="-127"/>
                  <a:cs typeface="Times New Roman" panose="02020603050405020304" pitchFamily="18" charset="0"/>
                </a:rPr>
                <a:t>&lt;Relative slow alpha – Females&gt;</a:t>
              </a:r>
              <a:endParaRPr lang="ko-KR" altLang="en-US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endParaRPr>
            </a:p>
          </p:txBody>
        </p:sp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F3BDD594-0103-CDCD-135B-D603401334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0611" y="889165"/>
              <a:ext cx="2040883" cy="2476800"/>
            </a:xfrm>
            <a:prstGeom prst="rect">
              <a:avLst/>
            </a:prstGeom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47702693-BBF0-FA27-79D4-B2BA55F731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77058" y="527978"/>
              <a:ext cx="933580" cy="285790"/>
            </a:xfrm>
            <a:prstGeom prst="rect">
              <a:avLst/>
            </a:prstGeom>
          </p:spPr>
        </p:pic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D2EAA1C9-878D-D9C4-8C14-3241A206C20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65506" y="889164"/>
              <a:ext cx="2018625" cy="2476800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62E266B7-AAFC-629B-065A-6D295941AD6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59046" y="547031"/>
              <a:ext cx="866896" cy="266737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7FBED905-7720-336A-FD49-DA350F9B1DF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237574" y="910419"/>
              <a:ext cx="2048629" cy="2476800"/>
            </a:xfrm>
            <a:prstGeom prst="rect">
              <a:avLst/>
            </a:prstGeom>
          </p:spPr>
        </p:pic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0E645661-1B9C-DA71-6127-D7573FF4158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874350" y="523214"/>
              <a:ext cx="876422" cy="314369"/>
            </a:xfrm>
            <a:prstGeom prst="rect">
              <a:avLst/>
            </a:prstGeom>
          </p:spPr>
        </p:pic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F823117F-9E23-E309-8AF4-D492F5B2A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699525" y="900965"/>
              <a:ext cx="2032414" cy="2476800"/>
            </a:xfrm>
            <a:prstGeom prst="rect">
              <a:avLst/>
            </a:prstGeom>
          </p:spPr>
        </p:pic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4644AB53-4BC4-4528-A6C9-9CFCCC7F068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324946" y="586597"/>
              <a:ext cx="828791" cy="314369"/>
            </a:xfrm>
            <a:prstGeom prst="rect">
              <a:avLst/>
            </a:prstGeom>
          </p:spPr>
        </p:pic>
        <p:pic>
          <p:nvPicPr>
            <p:cNvPr id="33" name="그림 32">
              <a:extLst>
                <a:ext uri="{FF2B5EF4-FFF2-40B4-BE49-F238E27FC236}">
                  <a16:creationId xmlns:a16="http://schemas.microsoft.com/office/drawing/2014/main" id="{D00E3114-CA85-F7C9-40A4-8FFFEE0B91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373154" y="3975724"/>
              <a:ext cx="2025879" cy="2476800"/>
            </a:xfrm>
            <a:prstGeom prst="rect">
              <a:avLst/>
            </a:prstGeom>
          </p:spPr>
        </p:pic>
        <p:pic>
          <p:nvPicPr>
            <p:cNvPr id="35" name="그림 34">
              <a:extLst>
                <a:ext uri="{FF2B5EF4-FFF2-40B4-BE49-F238E27FC236}">
                  <a16:creationId xmlns:a16="http://schemas.microsoft.com/office/drawing/2014/main" id="{6F19783A-CA82-AE84-F621-B72A8D47F5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896371" y="3601134"/>
              <a:ext cx="895475" cy="276264"/>
            </a:xfrm>
            <a:prstGeom prst="rect">
              <a:avLst/>
            </a:prstGeom>
          </p:spPr>
        </p:pic>
        <p:pic>
          <p:nvPicPr>
            <p:cNvPr id="37" name="그림 36">
              <a:extLst>
                <a:ext uri="{FF2B5EF4-FFF2-40B4-BE49-F238E27FC236}">
                  <a16:creationId xmlns:a16="http://schemas.microsoft.com/office/drawing/2014/main" id="{06A5E65C-0CD6-85A3-9DB8-0A976AF5D2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926421" y="3928745"/>
              <a:ext cx="2030056" cy="2476800"/>
            </a:xfrm>
            <a:prstGeom prst="rect">
              <a:avLst/>
            </a:prstGeom>
          </p:spPr>
        </p:pic>
        <p:pic>
          <p:nvPicPr>
            <p:cNvPr id="39" name="그림 38">
              <a:extLst>
                <a:ext uri="{FF2B5EF4-FFF2-40B4-BE49-F238E27FC236}">
                  <a16:creationId xmlns:a16="http://schemas.microsoft.com/office/drawing/2014/main" id="{EA1671EC-B0A5-D034-9707-9D60BDE7DD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442251" y="3566100"/>
              <a:ext cx="876422" cy="266737"/>
            </a:xfrm>
            <a:prstGeom prst="rect">
              <a:avLst/>
            </a:prstGeom>
          </p:spPr>
        </p:pic>
        <p:pic>
          <p:nvPicPr>
            <p:cNvPr id="41" name="그림 40">
              <a:extLst>
                <a:ext uri="{FF2B5EF4-FFF2-40B4-BE49-F238E27FC236}">
                  <a16:creationId xmlns:a16="http://schemas.microsoft.com/office/drawing/2014/main" id="{8D4B2F2C-C5C2-350C-99C7-35A1EB5DF8E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408466" y="3975724"/>
              <a:ext cx="2068391" cy="2476800"/>
            </a:xfrm>
            <a:prstGeom prst="rect">
              <a:avLst/>
            </a:prstGeom>
          </p:spPr>
        </p:pic>
        <p:pic>
          <p:nvPicPr>
            <p:cNvPr id="43" name="그림 42">
              <a:extLst>
                <a:ext uri="{FF2B5EF4-FFF2-40B4-BE49-F238E27FC236}">
                  <a16:creationId xmlns:a16="http://schemas.microsoft.com/office/drawing/2014/main" id="{28B42CEF-AD05-6D27-B427-E94842A9D65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7969078" y="3564945"/>
              <a:ext cx="885949" cy="285790"/>
            </a:xfrm>
            <a:prstGeom prst="rect">
              <a:avLst/>
            </a:prstGeom>
          </p:spPr>
        </p:pic>
        <p:sp>
          <p:nvSpPr>
            <p:cNvPr id="44" name="슬라이드 번호 개체 틀 3">
              <a:extLst>
                <a:ext uri="{FF2B5EF4-FFF2-40B4-BE49-F238E27FC236}">
                  <a16:creationId xmlns:a16="http://schemas.microsoft.com/office/drawing/2014/main" id="{C1610147-1294-59DA-E31A-3D999276BC81}"/>
                </a:ext>
              </a:extLst>
            </p:cNvPr>
            <p:cNvSpPr txBox="1">
              <a:spLocks/>
            </p:cNvSpPr>
            <p:nvPr/>
          </p:nvSpPr>
          <p:spPr>
            <a:xfrm>
              <a:off x="9334826" y="6452524"/>
              <a:ext cx="2743200" cy="365125"/>
            </a:xfrm>
            <a:prstGeom prst="rect">
              <a:avLst/>
            </a:prstGeom>
          </p:spPr>
          <p:txBody>
            <a:bodyPr vert="horz" lIns="91440" tIns="45720" rIns="91440" bIns="45720" rtlCol="0" anchor="ctr"/>
            <a:lstStyle>
              <a:defPPr>
                <a:defRPr lang="ko-KR"/>
              </a:defPPr>
              <a:lvl1pPr marL="0" algn="r" defTabSz="914400" rtl="0" eaLnBrk="1" latinLnBrk="1" hangingPunct="1">
                <a:defRPr sz="1200" kern="1200">
                  <a:solidFill>
                    <a:schemeClr val="tx1">
                      <a:tint val="82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lt;Fig</a:t>
              </a:r>
              <a:r>
                <a:rPr lang="en-US" altLang="ko-KR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ko-KR" sz="1400" b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1G</a:t>
              </a:r>
              <a:r>
                <a:rPr lang="en-US" altLang="ko-KR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endParaRPr lang="ko-KR" alt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7F33B4A-DA1C-23CD-61C5-5F924B91B158}"/>
                </a:ext>
              </a:extLst>
            </p:cNvPr>
            <p:cNvSpPr txBox="1"/>
            <p:nvPr/>
          </p:nvSpPr>
          <p:spPr>
            <a:xfrm>
              <a:off x="1652960" y="544301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Fp1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D66EA2C-61FC-9EE9-E37D-861388BD719C}"/>
                </a:ext>
              </a:extLst>
            </p:cNvPr>
            <p:cNvSpPr txBox="1"/>
            <p:nvPr/>
          </p:nvSpPr>
          <p:spPr>
            <a:xfrm>
              <a:off x="4247524" y="556516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F7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7D629EF-764C-DBAA-3528-411D9F418083}"/>
                </a:ext>
              </a:extLst>
            </p:cNvPr>
            <p:cNvSpPr txBox="1"/>
            <p:nvPr/>
          </p:nvSpPr>
          <p:spPr>
            <a:xfrm>
              <a:off x="6869018" y="592909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F3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C04C91E-13A0-DE29-AE90-E3547497A2F6}"/>
                </a:ext>
              </a:extLst>
            </p:cNvPr>
            <p:cNvSpPr txBox="1"/>
            <p:nvPr/>
          </p:nvSpPr>
          <p:spPr>
            <a:xfrm>
              <a:off x="9308163" y="599695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F8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3953F1A-554A-F163-C11D-35D3E126B7E3}"/>
                </a:ext>
              </a:extLst>
            </p:cNvPr>
            <p:cNvSpPr txBox="1"/>
            <p:nvPr/>
          </p:nvSpPr>
          <p:spPr>
            <a:xfrm>
              <a:off x="3000753" y="3643481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Pz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15A8D38-CA07-FE57-1479-FCE4A8ACF91D}"/>
                </a:ext>
              </a:extLst>
            </p:cNvPr>
            <p:cNvSpPr txBox="1"/>
            <p:nvPr/>
          </p:nvSpPr>
          <p:spPr>
            <a:xfrm>
              <a:off x="5559109" y="3598422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P4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25C2C90-319A-AE18-F595-6C4EA97C859A}"/>
                </a:ext>
              </a:extLst>
            </p:cNvPr>
            <p:cNvSpPr txBox="1"/>
            <p:nvPr/>
          </p:nvSpPr>
          <p:spPr>
            <a:xfrm>
              <a:off x="8011265" y="3623839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A_O2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C22BAB6-4D6F-A008-3987-D52C30EB4EBD}"/>
                </a:ext>
              </a:extLst>
            </p:cNvPr>
            <p:cNvSpPr txBox="1"/>
            <p:nvPr/>
          </p:nvSpPr>
          <p:spPr>
            <a:xfrm>
              <a:off x="603962" y="978312"/>
              <a:ext cx="631383" cy="21165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  <a:p>
              <a:pPr algn="r">
                <a:lnSpc>
                  <a:spcPct val="1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1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1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1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1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8D37753-95CE-88F3-5811-D84AE98467AF}"/>
                </a:ext>
              </a:extLst>
            </p:cNvPr>
            <p:cNvSpPr txBox="1"/>
            <p:nvPr/>
          </p:nvSpPr>
          <p:spPr>
            <a:xfrm rot="16200000">
              <a:off x="1681157" y="2642818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E1ABDD7-6C36-8748-67C4-E6FDEB822ED3}"/>
                </a:ext>
              </a:extLst>
            </p:cNvPr>
            <p:cNvSpPr txBox="1"/>
            <p:nvPr/>
          </p:nvSpPr>
          <p:spPr>
            <a:xfrm rot="16200000">
              <a:off x="4236025" y="2626059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436AB3A-6423-EC43-6435-3680CF521CCA}"/>
                </a:ext>
              </a:extLst>
            </p:cNvPr>
            <p:cNvSpPr txBox="1"/>
            <p:nvPr/>
          </p:nvSpPr>
          <p:spPr>
            <a:xfrm rot="16200000">
              <a:off x="6863139" y="2681567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0F6F1E3-2DDC-CC04-EB0A-C5B772FF0AAB}"/>
                </a:ext>
              </a:extLst>
            </p:cNvPr>
            <p:cNvSpPr txBox="1"/>
            <p:nvPr/>
          </p:nvSpPr>
          <p:spPr>
            <a:xfrm rot="16200000">
              <a:off x="9304863" y="2658404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22D89A1-4153-D455-64F1-0B178FC40F95}"/>
                </a:ext>
              </a:extLst>
            </p:cNvPr>
            <p:cNvSpPr txBox="1"/>
            <p:nvPr/>
          </p:nvSpPr>
          <p:spPr>
            <a:xfrm rot="16200000">
              <a:off x="2997696" y="5737460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4A91157-E2A6-0C49-406C-FDE6AB15D5AD}"/>
                </a:ext>
              </a:extLst>
            </p:cNvPr>
            <p:cNvSpPr txBox="1"/>
            <p:nvPr/>
          </p:nvSpPr>
          <p:spPr>
            <a:xfrm rot="16200000">
              <a:off x="5515736" y="5659345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3BC8840-BA34-F8B6-FCE0-11485BAE3695}"/>
                </a:ext>
              </a:extLst>
            </p:cNvPr>
            <p:cNvSpPr txBox="1"/>
            <p:nvPr/>
          </p:nvSpPr>
          <p:spPr>
            <a:xfrm rot="16200000">
              <a:off x="7983633" y="5739451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ABEC20F-799C-D0DD-EDEE-68ADB5FD6CA1}"/>
                </a:ext>
              </a:extLst>
            </p:cNvPr>
            <p:cNvSpPr txBox="1"/>
            <p:nvPr/>
          </p:nvSpPr>
          <p:spPr>
            <a:xfrm>
              <a:off x="3194116" y="975607"/>
              <a:ext cx="631383" cy="17502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C7D3294-F151-4830-ED04-1E14F8A84DF7}"/>
                </a:ext>
              </a:extLst>
            </p:cNvPr>
            <p:cNvSpPr txBox="1"/>
            <p:nvPr/>
          </p:nvSpPr>
          <p:spPr>
            <a:xfrm>
              <a:off x="5793985" y="804183"/>
              <a:ext cx="631383" cy="230236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6E1973E-C46F-9B27-7B73-93D0F23A1CF1}"/>
                </a:ext>
              </a:extLst>
            </p:cNvPr>
            <p:cNvSpPr txBox="1"/>
            <p:nvPr/>
          </p:nvSpPr>
          <p:spPr>
            <a:xfrm>
              <a:off x="8452473" y="837583"/>
              <a:ext cx="419601" cy="236430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175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34FCBF9-F229-3A1C-06B1-641978B0389A}"/>
                </a:ext>
              </a:extLst>
            </p:cNvPr>
            <p:cNvSpPr txBox="1"/>
            <p:nvPr/>
          </p:nvSpPr>
          <p:spPr>
            <a:xfrm>
              <a:off x="1922899" y="4067831"/>
              <a:ext cx="631383" cy="21811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2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559673F-261B-820B-C5DA-EE1FFA473FD3}"/>
                </a:ext>
              </a:extLst>
            </p:cNvPr>
            <p:cNvSpPr txBox="1"/>
            <p:nvPr/>
          </p:nvSpPr>
          <p:spPr>
            <a:xfrm>
              <a:off x="4455265" y="4213630"/>
              <a:ext cx="631383" cy="191187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0420BC4-BD4A-2FC4-58B3-CE1A2B5F6A93}"/>
                </a:ext>
              </a:extLst>
            </p:cNvPr>
            <p:cNvSpPr txBox="1"/>
            <p:nvPr/>
          </p:nvSpPr>
          <p:spPr>
            <a:xfrm>
              <a:off x="6951230" y="3966658"/>
              <a:ext cx="631383" cy="22350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</a:p>
            <a:p>
              <a:pPr algn="r">
                <a:lnSpc>
                  <a:spcPct val="2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</a:p>
            <a:p>
              <a:pPr algn="r">
                <a:lnSpc>
                  <a:spcPct val="2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26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9CD276EC-53B9-26E2-2A59-7C080ACE2462}"/>
              </a:ext>
            </a:extLst>
          </p:cNvPr>
          <p:cNvSpPr txBox="1"/>
          <p:nvPr/>
        </p:nvSpPr>
        <p:spPr>
          <a:xfrm>
            <a:off x="456397" y="559689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97B6B83-ACFB-6D38-DDD8-6B18BE144274}"/>
              </a:ext>
            </a:extLst>
          </p:cNvPr>
          <p:cNvSpPr txBox="1"/>
          <p:nvPr/>
        </p:nvSpPr>
        <p:spPr>
          <a:xfrm>
            <a:off x="3051729" y="552662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ED363B6-E578-852B-DB64-7EC66FD7C936}"/>
              </a:ext>
            </a:extLst>
          </p:cNvPr>
          <p:cNvSpPr txBox="1"/>
          <p:nvPr/>
        </p:nvSpPr>
        <p:spPr>
          <a:xfrm>
            <a:off x="5603792" y="608490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706EB03-2A23-738B-5F5D-56E4E19D08E8}"/>
              </a:ext>
            </a:extLst>
          </p:cNvPr>
          <p:cNvSpPr txBox="1"/>
          <p:nvPr/>
        </p:nvSpPr>
        <p:spPr>
          <a:xfrm>
            <a:off x="8034137" y="624398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89033F8-2F46-8E5A-BCD2-A997C8C0C4DC}"/>
              </a:ext>
            </a:extLst>
          </p:cNvPr>
          <p:cNvSpPr txBox="1"/>
          <p:nvPr/>
        </p:nvSpPr>
        <p:spPr>
          <a:xfrm>
            <a:off x="1773848" y="3689916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5FD26E2-41FB-F683-2078-B1E53455C05E}"/>
              </a:ext>
            </a:extLst>
          </p:cNvPr>
          <p:cNvSpPr txBox="1"/>
          <p:nvPr/>
        </p:nvSpPr>
        <p:spPr>
          <a:xfrm>
            <a:off x="4281311" y="3619634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A1022C0-3EFB-E6A9-433F-018AB36A5542}"/>
              </a:ext>
            </a:extLst>
          </p:cNvPr>
          <p:cNvSpPr txBox="1"/>
          <p:nvPr/>
        </p:nvSpPr>
        <p:spPr>
          <a:xfrm>
            <a:off x="6751719" y="3665902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0F652558-4D65-8A82-3543-55AC0630B263}"/>
              </a:ext>
            </a:extLst>
          </p:cNvPr>
          <p:cNvCxnSpPr>
            <a:cxnSpLocks/>
          </p:cNvCxnSpPr>
          <p:nvPr/>
        </p:nvCxnSpPr>
        <p:spPr>
          <a:xfrm>
            <a:off x="2118188" y="1593059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21B8B4C3-6C64-0B74-4AB5-A51BFFE824D9}"/>
              </a:ext>
            </a:extLst>
          </p:cNvPr>
          <p:cNvSpPr txBox="1"/>
          <p:nvPr/>
        </p:nvSpPr>
        <p:spPr>
          <a:xfrm>
            <a:off x="2278134" y="1530345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58AE5BAF-F5B5-6ADC-E3BC-DCB19C0AFAA6}"/>
              </a:ext>
            </a:extLst>
          </p:cNvPr>
          <p:cNvCxnSpPr>
            <a:cxnSpLocks/>
          </p:cNvCxnSpPr>
          <p:nvPr/>
        </p:nvCxnSpPr>
        <p:spPr>
          <a:xfrm>
            <a:off x="4687167" y="1334297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E6224DC-D25B-CAF1-5613-C42288BDA010}"/>
              </a:ext>
            </a:extLst>
          </p:cNvPr>
          <p:cNvSpPr txBox="1"/>
          <p:nvPr/>
        </p:nvSpPr>
        <p:spPr>
          <a:xfrm>
            <a:off x="4847113" y="1271583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5F24E10F-AAF4-3938-B51E-990FD3D02D9B}"/>
              </a:ext>
            </a:extLst>
          </p:cNvPr>
          <p:cNvCxnSpPr>
            <a:cxnSpLocks/>
          </p:cNvCxnSpPr>
          <p:nvPr/>
        </p:nvCxnSpPr>
        <p:spPr>
          <a:xfrm>
            <a:off x="7280199" y="1406468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536FC4A4-462F-5A0E-3A63-BA3DE33096F7}"/>
              </a:ext>
            </a:extLst>
          </p:cNvPr>
          <p:cNvSpPr txBox="1"/>
          <p:nvPr/>
        </p:nvSpPr>
        <p:spPr>
          <a:xfrm>
            <a:off x="7440145" y="1343754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8EA8D8D0-37F3-89C3-A2BC-F552DBF8718B}"/>
              </a:ext>
            </a:extLst>
          </p:cNvPr>
          <p:cNvCxnSpPr>
            <a:cxnSpLocks/>
          </p:cNvCxnSpPr>
          <p:nvPr/>
        </p:nvCxnSpPr>
        <p:spPr>
          <a:xfrm>
            <a:off x="3389150" y="4242278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4451AAF4-DF7D-806B-EF5B-FFE19DA867EE}"/>
              </a:ext>
            </a:extLst>
          </p:cNvPr>
          <p:cNvSpPr txBox="1"/>
          <p:nvPr/>
        </p:nvSpPr>
        <p:spPr>
          <a:xfrm>
            <a:off x="3549096" y="4179564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03" name="직선 연결선 102">
            <a:extLst>
              <a:ext uri="{FF2B5EF4-FFF2-40B4-BE49-F238E27FC236}">
                <a16:creationId xmlns:a16="http://schemas.microsoft.com/office/drawing/2014/main" id="{C97229E3-D166-A360-BB8B-CC682B9C21EA}"/>
              </a:ext>
            </a:extLst>
          </p:cNvPr>
          <p:cNvCxnSpPr>
            <a:cxnSpLocks/>
          </p:cNvCxnSpPr>
          <p:nvPr/>
        </p:nvCxnSpPr>
        <p:spPr>
          <a:xfrm>
            <a:off x="2559387" y="4316579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0F964B5A-0770-22D6-DA4B-7BD09138ABC8}"/>
              </a:ext>
            </a:extLst>
          </p:cNvPr>
          <p:cNvSpPr txBox="1"/>
          <p:nvPr/>
        </p:nvSpPr>
        <p:spPr>
          <a:xfrm>
            <a:off x="2540192" y="428350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7ED0F12C-B522-4926-9D3D-F7E877F4660C}"/>
              </a:ext>
            </a:extLst>
          </p:cNvPr>
          <p:cNvCxnSpPr>
            <a:cxnSpLocks/>
          </p:cNvCxnSpPr>
          <p:nvPr/>
        </p:nvCxnSpPr>
        <p:spPr>
          <a:xfrm>
            <a:off x="8921729" y="1459243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679A0836-0377-17F9-283A-80DF518A7296}"/>
              </a:ext>
            </a:extLst>
          </p:cNvPr>
          <p:cNvSpPr txBox="1"/>
          <p:nvPr/>
        </p:nvSpPr>
        <p:spPr>
          <a:xfrm>
            <a:off x="8894006" y="1436558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07" name="직선 연결선 106">
            <a:extLst>
              <a:ext uri="{FF2B5EF4-FFF2-40B4-BE49-F238E27FC236}">
                <a16:creationId xmlns:a16="http://schemas.microsoft.com/office/drawing/2014/main" id="{4CA08B9B-4311-F17B-ED99-07D332208E7B}"/>
              </a:ext>
            </a:extLst>
          </p:cNvPr>
          <p:cNvCxnSpPr>
            <a:cxnSpLocks/>
          </p:cNvCxnSpPr>
          <p:nvPr/>
        </p:nvCxnSpPr>
        <p:spPr>
          <a:xfrm>
            <a:off x="9730496" y="1304619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163213EE-0253-32BF-046C-36798B4A30F9}"/>
              </a:ext>
            </a:extLst>
          </p:cNvPr>
          <p:cNvSpPr txBox="1"/>
          <p:nvPr/>
        </p:nvSpPr>
        <p:spPr>
          <a:xfrm>
            <a:off x="9890442" y="1241905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0C5378CE-EC5D-E412-D65F-5AC8E7F5DB00}"/>
              </a:ext>
            </a:extLst>
          </p:cNvPr>
          <p:cNvCxnSpPr>
            <a:cxnSpLocks/>
          </p:cNvCxnSpPr>
          <p:nvPr/>
        </p:nvCxnSpPr>
        <p:spPr>
          <a:xfrm>
            <a:off x="5975280" y="4379274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ED5AAD77-11C3-F369-1469-82A0965115D8}"/>
              </a:ext>
            </a:extLst>
          </p:cNvPr>
          <p:cNvSpPr txBox="1"/>
          <p:nvPr/>
        </p:nvSpPr>
        <p:spPr>
          <a:xfrm>
            <a:off x="6135226" y="4316560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D8305A86-A2F7-F1DA-1720-232D467A3330}"/>
              </a:ext>
            </a:extLst>
          </p:cNvPr>
          <p:cNvCxnSpPr>
            <a:cxnSpLocks/>
          </p:cNvCxnSpPr>
          <p:nvPr/>
        </p:nvCxnSpPr>
        <p:spPr>
          <a:xfrm>
            <a:off x="8478679" y="4555892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57A22A09-B940-08ED-EA26-5C3AF27346ED}"/>
              </a:ext>
            </a:extLst>
          </p:cNvPr>
          <p:cNvSpPr txBox="1"/>
          <p:nvPr/>
        </p:nvSpPr>
        <p:spPr>
          <a:xfrm>
            <a:off x="8638625" y="4493178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11791060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056FBC-0DA2-F298-7888-91808EE4AC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FE781DB-8CF1-4FD8-83B7-745FF637C08D}"/>
              </a:ext>
            </a:extLst>
          </p:cNvPr>
          <p:cNvSpPr txBox="1"/>
          <p:nvPr/>
        </p:nvSpPr>
        <p:spPr>
          <a:xfrm>
            <a:off x="3163635" y="746413"/>
            <a:ext cx="57204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low beta – 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17" name="슬라이드 번호 개체 틀 3">
            <a:extLst>
              <a:ext uri="{FF2B5EF4-FFF2-40B4-BE49-F238E27FC236}">
                <a16:creationId xmlns:a16="http://schemas.microsoft.com/office/drawing/2014/main" id="{4C92F108-5F3B-F75D-DE10-698477C3F4BE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H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그룹 18">
            <a:extLst>
              <a:ext uri="{FF2B5EF4-FFF2-40B4-BE49-F238E27FC236}">
                <a16:creationId xmlns:a16="http://schemas.microsoft.com/office/drawing/2014/main" id="{2E496E49-185F-FD12-BBFB-6CA6DA0E345C}"/>
              </a:ext>
            </a:extLst>
          </p:cNvPr>
          <p:cNvGrpSpPr/>
          <p:nvPr/>
        </p:nvGrpSpPr>
        <p:grpSpPr>
          <a:xfrm>
            <a:off x="1384222" y="1666346"/>
            <a:ext cx="9297577" cy="3322677"/>
            <a:chOff x="1384222" y="1666346"/>
            <a:chExt cx="9297577" cy="3322677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CBC16007-FA1A-4CCB-F2C9-905E7512B2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21012" y="2022906"/>
              <a:ext cx="2104929" cy="2476800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92571C85-69FD-0856-41BC-600A9833492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00936" y="1666346"/>
              <a:ext cx="828791" cy="285790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6C7FCBBA-4BC9-DA4E-2130-21B9EB3952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28931" y="2022906"/>
              <a:ext cx="1978672" cy="24768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383B31A7-F6B8-5351-FB9C-C2B907544C6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24151" y="1666346"/>
              <a:ext cx="762106" cy="333422"/>
            </a:xfrm>
            <a:prstGeom prst="rect">
              <a:avLst/>
            </a:prstGeom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74E6471C-2FB6-0A4D-292E-B47F1D1E52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410987" y="2011128"/>
              <a:ext cx="1968917" cy="2476800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9EE4BC29-9D41-482C-2F80-E8FBDE8D89F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461377" y="1709315"/>
              <a:ext cx="828791" cy="247685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DFE3F22-07D2-DCB2-AA9C-969CA9024951}"/>
                </a:ext>
              </a:extLst>
            </p:cNvPr>
            <p:cNvSpPr txBox="1"/>
            <p:nvPr/>
          </p:nvSpPr>
          <p:spPr>
            <a:xfrm>
              <a:off x="2382612" y="1666346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LB_P4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B7DACCF-F9AF-4DEC-3227-CCB503EF3098}"/>
                </a:ext>
              </a:extLst>
            </p:cNvPr>
            <p:cNvSpPr txBox="1"/>
            <p:nvPr/>
          </p:nvSpPr>
          <p:spPr>
            <a:xfrm>
              <a:off x="5747181" y="1670645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LB_O1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778D133-D4B2-9D05-93F8-2DFB418DEBCA}"/>
                </a:ext>
              </a:extLst>
            </p:cNvPr>
            <p:cNvSpPr txBox="1"/>
            <p:nvPr/>
          </p:nvSpPr>
          <p:spPr>
            <a:xfrm>
              <a:off x="8990651" y="1670645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LB_Oz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84261EF-6CAC-A389-A98D-1417F467E390}"/>
                </a:ext>
              </a:extLst>
            </p:cNvPr>
            <p:cNvSpPr txBox="1"/>
            <p:nvPr/>
          </p:nvSpPr>
          <p:spPr>
            <a:xfrm>
              <a:off x="1384222" y="2150170"/>
              <a:ext cx="631383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9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6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9B5626B-410B-0906-1D52-D6786B202A16}"/>
                </a:ext>
              </a:extLst>
            </p:cNvPr>
            <p:cNvSpPr txBox="1"/>
            <p:nvPr/>
          </p:nvSpPr>
          <p:spPr>
            <a:xfrm rot="16200000">
              <a:off x="2414170" y="3753863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ADD3829-2117-29DD-1416-6230DEC9F747}"/>
                </a:ext>
              </a:extLst>
            </p:cNvPr>
            <p:cNvSpPr txBox="1"/>
            <p:nvPr/>
          </p:nvSpPr>
          <p:spPr>
            <a:xfrm rot="16200000">
              <a:off x="9017264" y="3744032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174487D-340A-97B7-ECA1-7F077C70D0E3}"/>
                </a:ext>
              </a:extLst>
            </p:cNvPr>
            <p:cNvSpPr txBox="1"/>
            <p:nvPr/>
          </p:nvSpPr>
          <p:spPr>
            <a:xfrm rot="16200000">
              <a:off x="5676327" y="3793192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2A86A27-2C4B-E1C6-C55F-DC35EE0A5295}"/>
                </a:ext>
              </a:extLst>
            </p:cNvPr>
            <p:cNvSpPr txBox="1"/>
            <p:nvPr/>
          </p:nvSpPr>
          <p:spPr>
            <a:xfrm>
              <a:off x="4657400" y="2117092"/>
              <a:ext cx="631383" cy="21542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75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50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5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2ADE69D-45AF-A2E2-3936-71AAC391156C}"/>
                </a:ext>
              </a:extLst>
            </p:cNvPr>
            <p:cNvSpPr txBox="1"/>
            <p:nvPr/>
          </p:nvSpPr>
          <p:spPr>
            <a:xfrm>
              <a:off x="8002067" y="2117564"/>
              <a:ext cx="631383" cy="21542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75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50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5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A2D7D85F-794F-FB2B-0B6C-8F6B41EC619B}"/>
              </a:ext>
            </a:extLst>
          </p:cNvPr>
          <p:cNvSpPr txBox="1"/>
          <p:nvPr/>
        </p:nvSpPr>
        <p:spPr>
          <a:xfrm>
            <a:off x="1102663" y="1691991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BE4D626-DCD5-6737-5B9C-2E7C8A6F0AAC}"/>
              </a:ext>
            </a:extLst>
          </p:cNvPr>
          <p:cNvSpPr txBox="1"/>
          <p:nvPr/>
        </p:nvSpPr>
        <p:spPr>
          <a:xfrm>
            <a:off x="4402056" y="1715129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8C29EBC-0059-8D12-0497-ECFD1FD87C3D}"/>
              </a:ext>
            </a:extLst>
          </p:cNvPr>
          <p:cNvSpPr txBox="1"/>
          <p:nvPr/>
        </p:nvSpPr>
        <p:spPr>
          <a:xfrm>
            <a:off x="7683860" y="1715129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F58D09AF-795B-8E90-53D2-171CE32A4DF3}"/>
              </a:ext>
            </a:extLst>
          </p:cNvPr>
          <p:cNvCxnSpPr>
            <a:cxnSpLocks/>
          </p:cNvCxnSpPr>
          <p:nvPr/>
        </p:nvCxnSpPr>
        <p:spPr>
          <a:xfrm>
            <a:off x="2570825" y="2317429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752CA359-046E-0E20-2D62-6D0D3B66B59F}"/>
              </a:ext>
            </a:extLst>
          </p:cNvPr>
          <p:cNvSpPr txBox="1"/>
          <p:nvPr/>
        </p:nvSpPr>
        <p:spPr>
          <a:xfrm>
            <a:off x="2586288" y="231500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916F5EB0-99ED-882B-20D0-A189B2E41A1C}"/>
              </a:ext>
            </a:extLst>
          </p:cNvPr>
          <p:cNvCxnSpPr>
            <a:cxnSpLocks/>
          </p:cNvCxnSpPr>
          <p:nvPr/>
        </p:nvCxnSpPr>
        <p:spPr>
          <a:xfrm>
            <a:off x="5892276" y="2394875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152277FD-C5AF-EF6C-5CC2-9670BA414B88}"/>
              </a:ext>
            </a:extLst>
          </p:cNvPr>
          <p:cNvSpPr txBox="1"/>
          <p:nvPr/>
        </p:nvSpPr>
        <p:spPr>
          <a:xfrm>
            <a:off x="5907739" y="2392447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9B452144-E292-709A-FCC3-5B09FD51102E}"/>
              </a:ext>
            </a:extLst>
          </p:cNvPr>
          <p:cNvCxnSpPr>
            <a:cxnSpLocks/>
          </p:cNvCxnSpPr>
          <p:nvPr/>
        </p:nvCxnSpPr>
        <p:spPr>
          <a:xfrm>
            <a:off x="9131574" y="2245052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7676DD1-2C8F-21DB-64CC-64A175AFF5BA}"/>
              </a:ext>
            </a:extLst>
          </p:cNvPr>
          <p:cNvSpPr txBox="1"/>
          <p:nvPr/>
        </p:nvSpPr>
        <p:spPr>
          <a:xfrm>
            <a:off x="9147037" y="2242624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9005842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BA8F64-DAA2-6C1F-E94D-66ABB63A8B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CB6A87-0823-B6D5-17C2-0B285B8E3588}"/>
              </a:ext>
            </a:extLst>
          </p:cNvPr>
          <p:cNvSpPr txBox="1"/>
          <p:nvPr/>
        </p:nvSpPr>
        <p:spPr>
          <a:xfrm>
            <a:off x="3163635" y="797053"/>
            <a:ext cx="57204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low beta – Fe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14" name="슬라이드 번호 개체 틀 3">
            <a:extLst>
              <a:ext uri="{FF2B5EF4-FFF2-40B4-BE49-F238E27FC236}">
                <a16:creationId xmlns:a16="http://schemas.microsoft.com/office/drawing/2014/main" id="{AC2D9453-E5A9-EBDE-8C96-DDDACA604937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I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43B04622-461F-43DC-8403-AC680614B4FB}"/>
              </a:ext>
            </a:extLst>
          </p:cNvPr>
          <p:cNvGrpSpPr/>
          <p:nvPr/>
        </p:nvGrpSpPr>
        <p:grpSpPr>
          <a:xfrm>
            <a:off x="2572892" y="1859189"/>
            <a:ext cx="6601167" cy="3297747"/>
            <a:chOff x="2572892" y="1859189"/>
            <a:chExt cx="6601167" cy="3297747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A3D47E53-9B7A-6CC7-8704-960ABCAE27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836317" y="2232041"/>
              <a:ext cx="2047748" cy="2476800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E31653E0-A46F-2455-01D3-8EA209CD7D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478754" y="1877654"/>
              <a:ext cx="962159" cy="285790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C8F9E225-E909-AD85-0A36-8BB1764FB1C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65468" y="2232041"/>
              <a:ext cx="1964582" cy="2476800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00A6D70B-AFAD-D392-2262-5D6C2A78EC4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53086" y="1896707"/>
              <a:ext cx="800212" cy="247685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2236E6F-5344-EE0E-651C-DCB215A37C61}"/>
                </a:ext>
              </a:extLst>
            </p:cNvPr>
            <p:cNvSpPr txBox="1"/>
            <p:nvPr/>
          </p:nvSpPr>
          <p:spPr>
            <a:xfrm>
              <a:off x="3514274" y="1877654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LB_Fp1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07C9163-A877-1743-FC4F-875F630CA563}"/>
                </a:ext>
              </a:extLst>
            </p:cNvPr>
            <p:cNvSpPr txBox="1"/>
            <p:nvPr/>
          </p:nvSpPr>
          <p:spPr>
            <a:xfrm>
              <a:off x="2572892" y="2307347"/>
              <a:ext cx="631383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75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50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5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06A2754-5DFE-14BB-7E39-9C253A9305E4}"/>
                </a:ext>
              </a:extLst>
            </p:cNvPr>
            <p:cNvSpPr txBox="1"/>
            <p:nvPr/>
          </p:nvSpPr>
          <p:spPr>
            <a:xfrm rot="16200000">
              <a:off x="3553944" y="3936521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2968DAA-0D54-B44A-D4B9-E8F8F9D19043}"/>
                </a:ext>
              </a:extLst>
            </p:cNvPr>
            <p:cNvSpPr txBox="1"/>
            <p:nvPr/>
          </p:nvSpPr>
          <p:spPr>
            <a:xfrm>
              <a:off x="7482911" y="1859189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LB_F8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D97956B-2E4E-C743-D535-756E011055F3}"/>
                </a:ext>
              </a:extLst>
            </p:cNvPr>
            <p:cNvSpPr txBox="1"/>
            <p:nvPr/>
          </p:nvSpPr>
          <p:spPr>
            <a:xfrm rot="16200000">
              <a:off x="7501604" y="3961105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A1A8CD9-0421-BB04-342B-FEC66CAEB459}"/>
                </a:ext>
              </a:extLst>
            </p:cNvPr>
            <p:cNvSpPr txBox="1"/>
            <p:nvPr/>
          </p:nvSpPr>
          <p:spPr>
            <a:xfrm>
              <a:off x="6461082" y="1936558"/>
              <a:ext cx="631383" cy="21542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8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6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4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AA6377B3-C87C-2FC9-3BAA-D634FD7D904D}"/>
              </a:ext>
            </a:extLst>
          </p:cNvPr>
          <p:cNvSpPr txBox="1"/>
          <p:nvPr/>
        </p:nvSpPr>
        <p:spPr>
          <a:xfrm>
            <a:off x="2368416" y="1916347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1C29A19-55DD-2C32-648B-73BA45DACFEA}"/>
              </a:ext>
            </a:extLst>
          </p:cNvPr>
          <p:cNvSpPr txBox="1"/>
          <p:nvPr/>
        </p:nvSpPr>
        <p:spPr>
          <a:xfrm>
            <a:off x="6263653" y="1916347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74283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0504BC-B72C-0885-EA9C-CAAA0728C1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EC1C776-94F7-DBC4-A116-ABBEEED5FD49}"/>
              </a:ext>
            </a:extLst>
          </p:cNvPr>
          <p:cNvSpPr txBox="1"/>
          <p:nvPr/>
        </p:nvSpPr>
        <p:spPr>
          <a:xfrm>
            <a:off x="3163635" y="797053"/>
            <a:ext cx="57204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&lt;Relative high beta – Males&gt;</a:t>
            </a:r>
            <a:endParaRPr lang="ko-KR" altLang="en-US" sz="2000" b="1" dirty="0"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12" name="슬라이드 번호 개체 틀 3">
            <a:extLst>
              <a:ext uri="{FF2B5EF4-FFF2-40B4-BE49-F238E27FC236}">
                <a16:creationId xmlns:a16="http://schemas.microsoft.com/office/drawing/2014/main" id="{0E6043CC-7B53-C0B3-212C-BD80BD259AE9}"/>
              </a:ext>
            </a:extLst>
          </p:cNvPr>
          <p:cNvSpPr txBox="1">
            <a:spLocks/>
          </p:cNvSpPr>
          <p:nvPr/>
        </p:nvSpPr>
        <p:spPr>
          <a:xfrm>
            <a:off x="9361712" y="650292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Fig</a:t>
            </a:r>
            <a:r>
              <a:rPr lang="en-US" altLang="ko-KR" sz="14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b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J&gt;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6CDF4378-D123-43C6-91C8-3F70C4B733A8}"/>
              </a:ext>
            </a:extLst>
          </p:cNvPr>
          <p:cNvGrpSpPr/>
          <p:nvPr/>
        </p:nvGrpSpPr>
        <p:grpSpPr>
          <a:xfrm>
            <a:off x="4744837" y="1644567"/>
            <a:ext cx="2702325" cy="3225787"/>
            <a:chOff x="2152458" y="1728337"/>
            <a:chExt cx="2702325" cy="3225787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A31C77DE-F636-3EAD-A7CE-2A6F922591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05794" y="2080960"/>
              <a:ext cx="1980000" cy="2420710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0A5C0E83-AE01-46BD-EFE1-E5A8B20905D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4353" y="1828733"/>
              <a:ext cx="743054" cy="23815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A85795B-B4F4-C67C-9EDE-4845D7E5B460}"/>
                </a:ext>
              </a:extLst>
            </p:cNvPr>
            <p:cNvSpPr txBox="1"/>
            <p:nvPr/>
          </p:nvSpPr>
          <p:spPr>
            <a:xfrm>
              <a:off x="3163635" y="1728337"/>
              <a:ext cx="16911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HB_T3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48275E1-A2AD-2C9E-E5DA-44EC2C82BA58}"/>
                </a:ext>
              </a:extLst>
            </p:cNvPr>
            <p:cNvSpPr txBox="1"/>
            <p:nvPr/>
          </p:nvSpPr>
          <p:spPr>
            <a:xfrm>
              <a:off x="2152458" y="2314083"/>
              <a:ext cx="631383" cy="191187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>
                <a:lnSpc>
                  <a:spcPct val="30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4C952B0-2185-676A-F641-4E0CE1F6C873}"/>
                </a:ext>
              </a:extLst>
            </p:cNvPr>
            <p:cNvSpPr txBox="1"/>
            <p:nvPr/>
          </p:nvSpPr>
          <p:spPr>
            <a:xfrm rot="16200000">
              <a:off x="3188117" y="3758293"/>
              <a:ext cx="776026" cy="161563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</a:p>
            <a:p>
              <a:pPr algn="r">
                <a:lnSpc>
                  <a:spcPct val="250000"/>
                </a:lnSpc>
              </a:pPr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6084F83B-645B-5FC9-61C1-C89844765D35}"/>
              </a:ext>
            </a:extLst>
          </p:cNvPr>
          <p:cNvSpPr txBox="1"/>
          <p:nvPr/>
        </p:nvSpPr>
        <p:spPr>
          <a:xfrm>
            <a:off x="4610687" y="1731330"/>
            <a:ext cx="11453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µV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EF27EED7-CCC6-7D31-91C7-E780E4D109B7}"/>
              </a:ext>
            </a:extLst>
          </p:cNvPr>
          <p:cNvCxnSpPr>
            <a:cxnSpLocks/>
          </p:cNvCxnSpPr>
          <p:nvPr/>
        </p:nvCxnSpPr>
        <p:spPr>
          <a:xfrm>
            <a:off x="5988647" y="2248981"/>
            <a:ext cx="879023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AEE094A-6E8F-5622-C209-5CA244DDA57A}"/>
              </a:ext>
            </a:extLst>
          </p:cNvPr>
          <p:cNvSpPr txBox="1"/>
          <p:nvPr/>
        </p:nvSpPr>
        <p:spPr>
          <a:xfrm>
            <a:off x="5894779" y="224898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56B83085-2A89-BDCE-FEE3-7B254A724ED9}"/>
              </a:ext>
            </a:extLst>
          </p:cNvPr>
          <p:cNvCxnSpPr>
            <a:cxnSpLocks/>
          </p:cNvCxnSpPr>
          <p:nvPr/>
        </p:nvCxnSpPr>
        <p:spPr>
          <a:xfrm>
            <a:off x="5475435" y="2120301"/>
            <a:ext cx="1284351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6B5063E-2797-7E16-F437-C89373CD59B0}"/>
              </a:ext>
            </a:extLst>
          </p:cNvPr>
          <p:cNvSpPr txBox="1"/>
          <p:nvPr/>
        </p:nvSpPr>
        <p:spPr>
          <a:xfrm>
            <a:off x="5371628" y="2120301"/>
            <a:ext cx="72507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b="1" dirty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862878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557</Words>
  <Application>Microsoft Office PowerPoint</Application>
  <PresentationFormat>와이드스크린</PresentationFormat>
  <Paragraphs>340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5" baseType="lpstr">
      <vt:lpstr>맑은 고딕</vt:lpstr>
      <vt:lpstr>바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3</cp:revision>
  <dcterms:created xsi:type="dcterms:W3CDTF">2025-08-27T09:35:24Z</dcterms:created>
  <dcterms:modified xsi:type="dcterms:W3CDTF">2025-08-28T14:25:19Z</dcterms:modified>
</cp:coreProperties>
</file>